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334" r:id="rId2"/>
    <p:sldId id="338" r:id="rId3"/>
    <p:sldId id="333" r:id="rId4"/>
    <p:sldId id="342" r:id="rId5"/>
    <p:sldId id="341" r:id="rId6"/>
    <p:sldId id="263" r:id="rId7"/>
    <p:sldId id="337" r:id="rId8"/>
    <p:sldId id="340" r:id="rId9"/>
  </p:sldIdLst>
  <p:sldSz cx="12192000" cy="868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3792" autoAdjust="0"/>
  </p:normalViewPr>
  <p:slideViewPr>
    <p:cSldViewPr snapToGrid="0">
      <p:cViewPr varScale="1">
        <p:scale>
          <a:sx n="53" d="100"/>
          <a:sy n="53" d="100"/>
        </p:scale>
        <p:origin x="117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608BA3-23CF-4FA0-8DCE-B6F7E1534E45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63650" y="1143000"/>
            <a:ext cx="4330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3A3DEA-B02C-4CCF-A06F-4947DD8A3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8510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1403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Tabl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373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9380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630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6721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6332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8886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63650" y="1143000"/>
            <a:ext cx="4330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7</a:t>
            </a:r>
            <a:endParaRPr lang="en-US" b="0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02869-92B5-45D8-97C1-0F577926003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80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21660"/>
            <a:ext cx="10363200" cy="3024293"/>
          </a:xfrm>
        </p:spPr>
        <p:txBody>
          <a:bodyPr anchor="b"/>
          <a:lstStyle>
            <a:lvl1pPr algn="ctr">
              <a:defRPr sz="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562581"/>
            <a:ext cx="9144000" cy="2097299"/>
          </a:xfrm>
        </p:spPr>
        <p:txBody>
          <a:bodyPr/>
          <a:lstStyle>
            <a:lvl1pPr marL="0" indent="0" algn="ctr">
              <a:buNone/>
              <a:defRPr sz="3040"/>
            </a:lvl1pPr>
            <a:lvl2pPr marL="579135" indent="0" algn="ctr">
              <a:buNone/>
              <a:defRPr sz="2533"/>
            </a:lvl2pPr>
            <a:lvl3pPr marL="1158270" indent="0" algn="ctr">
              <a:buNone/>
              <a:defRPr sz="2280"/>
            </a:lvl3pPr>
            <a:lvl4pPr marL="1737406" indent="0" algn="ctr">
              <a:buNone/>
              <a:defRPr sz="2027"/>
            </a:lvl4pPr>
            <a:lvl5pPr marL="2316541" indent="0" algn="ctr">
              <a:buNone/>
              <a:defRPr sz="2027"/>
            </a:lvl5pPr>
            <a:lvl6pPr marL="2895676" indent="0" algn="ctr">
              <a:buNone/>
              <a:defRPr sz="2027"/>
            </a:lvl6pPr>
            <a:lvl7pPr marL="3474811" indent="0" algn="ctr">
              <a:buNone/>
              <a:defRPr sz="2027"/>
            </a:lvl7pPr>
            <a:lvl8pPr marL="4053947" indent="0" algn="ctr">
              <a:buNone/>
              <a:defRPr sz="2027"/>
            </a:lvl8pPr>
            <a:lvl9pPr marL="4633082" indent="0" algn="ctr">
              <a:buNone/>
              <a:defRPr sz="202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044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318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62492"/>
            <a:ext cx="2628900" cy="73616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62492"/>
            <a:ext cx="7734300" cy="736166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721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346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165670"/>
            <a:ext cx="10515600" cy="3613467"/>
          </a:xfrm>
        </p:spPr>
        <p:txBody>
          <a:bodyPr anchor="b"/>
          <a:lstStyle>
            <a:lvl1pPr>
              <a:defRPr sz="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813322"/>
            <a:ext cx="10515600" cy="1900237"/>
          </a:xfrm>
        </p:spPr>
        <p:txBody>
          <a:bodyPr/>
          <a:lstStyle>
            <a:lvl1pPr marL="0" indent="0">
              <a:buNone/>
              <a:defRPr sz="3040">
                <a:solidFill>
                  <a:schemeClr val="tx1"/>
                </a:solidFill>
              </a:defRPr>
            </a:lvl1pPr>
            <a:lvl2pPr marL="579135" indent="0">
              <a:buNone/>
              <a:defRPr sz="2533">
                <a:solidFill>
                  <a:schemeClr val="tx1">
                    <a:tint val="75000"/>
                  </a:schemeClr>
                </a:solidFill>
              </a:defRPr>
            </a:lvl2pPr>
            <a:lvl3pPr marL="1158270" indent="0">
              <a:buNone/>
              <a:defRPr sz="2280">
                <a:solidFill>
                  <a:schemeClr val="tx1">
                    <a:tint val="75000"/>
                  </a:schemeClr>
                </a:solidFill>
              </a:defRPr>
            </a:lvl3pPr>
            <a:lvl4pPr marL="1737406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4pPr>
            <a:lvl5pPr marL="2316541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5pPr>
            <a:lvl6pPr marL="2895676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6pPr>
            <a:lvl7pPr marL="3474811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7pPr>
            <a:lvl8pPr marL="4053947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8pPr>
            <a:lvl9pPr marL="4633082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1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12458"/>
            <a:ext cx="518160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12458"/>
            <a:ext cx="518160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484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62494"/>
            <a:ext cx="10515600" cy="167904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129473"/>
            <a:ext cx="5157787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35" indent="0">
              <a:buNone/>
              <a:defRPr sz="2533" b="1"/>
            </a:lvl2pPr>
            <a:lvl3pPr marL="1158270" indent="0">
              <a:buNone/>
              <a:defRPr sz="2280" b="1"/>
            </a:lvl3pPr>
            <a:lvl4pPr marL="1737406" indent="0">
              <a:buNone/>
              <a:defRPr sz="2027" b="1"/>
            </a:lvl4pPr>
            <a:lvl5pPr marL="2316541" indent="0">
              <a:buNone/>
              <a:defRPr sz="2027" b="1"/>
            </a:lvl5pPr>
            <a:lvl6pPr marL="2895676" indent="0">
              <a:buNone/>
              <a:defRPr sz="2027" b="1"/>
            </a:lvl6pPr>
            <a:lvl7pPr marL="3474811" indent="0">
              <a:buNone/>
              <a:defRPr sz="2027" b="1"/>
            </a:lvl7pPr>
            <a:lvl8pPr marL="4053947" indent="0">
              <a:buNone/>
              <a:defRPr sz="2027" b="1"/>
            </a:lvl8pPr>
            <a:lvl9pPr marL="4633082" indent="0">
              <a:buNone/>
              <a:defRPr sz="20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173095"/>
            <a:ext cx="5157787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129473"/>
            <a:ext cx="5183188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35" indent="0">
              <a:buNone/>
              <a:defRPr sz="2533" b="1"/>
            </a:lvl2pPr>
            <a:lvl3pPr marL="1158270" indent="0">
              <a:buNone/>
              <a:defRPr sz="2280" b="1"/>
            </a:lvl3pPr>
            <a:lvl4pPr marL="1737406" indent="0">
              <a:buNone/>
              <a:defRPr sz="2027" b="1"/>
            </a:lvl4pPr>
            <a:lvl5pPr marL="2316541" indent="0">
              <a:buNone/>
              <a:defRPr sz="2027" b="1"/>
            </a:lvl5pPr>
            <a:lvl6pPr marL="2895676" indent="0">
              <a:buNone/>
              <a:defRPr sz="2027" b="1"/>
            </a:lvl6pPr>
            <a:lvl7pPr marL="3474811" indent="0">
              <a:buNone/>
              <a:defRPr sz="2027" b="1"/>
            </a:lvl7pPr>
            <a:lvl8pPr marL="4053947" indent="0">
              <a:buNone/>
              <a:defRPr sz="2027" b="1"/>
            </a:lvl8pPr>
            <a:lvl9pPr marL="4633082" indent="0">
              <a:buNone/>
              <a:defRPr sz="20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173095"/>
            <a:ext cx="5183188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57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561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302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9120"/>
            <a:ext cx="3932237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50740"/>
            <a:ext cx="6172200" cy="6173258"/>
          </a:xfrm>
        </p:spPr>
        <p:txBody>
          <a:bodyPr/>
          <a:lstStyle>
            <a:lvl1pPr>
              <a:defRPr sz="4053"/>
            </a:lvl1pPr>
            <a:lvl2pPr>
              <a:defRPr sz="3547"/>
            </a:lvl2pPr>
            <a:lvl3pPr>
              <a:defRPr sz="3040"/>
            </a:lvl3pPr>
            <a:lvl4pPr>
              <a:defRPr sz="2533"/>
            </a:lvl4pPr>
            <a:lvl5pPr>
              <a:defRPr sz="2533"/>
            </a:lvl5pPr>
            <a:lvl6pPr>
              <a:defRPr sz="2533"/>
            </a:lvl6pPr>
            <a:lvl7pPr>
              <a:defRPr sz="2533"/>
            </a:lvl7pPr>
            <a:lvl8pPr>
              <a:defRPr sz="2533"/>
            </a:lvl8pPr>
            <a:lvl9pPr>
              <a:defRPr sz="25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06040"/>
            <a:ext cx="3932237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35" indent="0">
              <a:buNone/>
              <a:defRPr sz="1773"/>
            </a:lvl2pPr>
            <a:lvl3pPr marL="1158270" indent="0">
              <a:buNone/>
              <a:defRPr sz="1520"/>
            </a:lvl3pPr>
            <a:lvl4pPr marL="1737406" indent="0">
              <a:buNone/>
              <a:defRPr sz="1267"/>
            </a:lvl4pPr>
            <a:lvl5pPr marL="2316541" indent="0">
              <a:buNone/>
              <a:defRPr sz="1267"/>
            </a:lvl5pPr>
            <a:lvl6pPr marL="2895676" indent="0">
              <a:buNone/>
              <a:defRPr sz="1267"/>
            </a:lvl6pPr>
            <a:lvl7pPr marL="3474811" indent="0">
              <a:buNone/>
              <a:defRPr sz="1267"/>
            </a:lvl7pPr>
            <a:lvl8pPr marL="4053947" indent="0">
              <a:buNone/>
              <a:defRPr sz="1267"/>
            </a:lvl8pPr>
            <a:lvl9pPr marL="4633082" indent="0">
              <a:buNone/>
              <a:defRPr sz="1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660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9120"/>
            <a:ext cx="3932237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50740"/>
            <a:ext cx="6172200" cy="6173258"/>
          </a:xfrm>
        </p:spPr>
        <p:txBody>
          <a:bodyPr anchor="t"/>
          <a:lstStyle>
            <a:lvl1pPr marL="0" indent="0">
              <a:buNone/>
              <a:defRPr sz="4053"/>
            </a:lvl1pPr>
            <a:lvl2pPr marL="579135" indent="0">
              <a:buNone/>
              <a:defRPr sz="3547"/>
            </a:lvl2pPr>
            <a:lvl3pPr marL="1158270" indent="0">
              <a:buNone/>
              <a:defRPr sz="3040"/>
            </a:lvl3pPr>
            <a:lvl4pPr marL="1737406" indent="0">
              <a:buNone/>
              <a:defRPr sz="2533"/>
            </a:lvl4pPr>
            <a:lvl5pPr marL="2316541" indent="0">
              <a:buNone/>
              <a:defRPr sz="2533"/>
            </a:lvl5pPr>
            <a:lvl6pPr marL="2895676" indent="0">
              <a:buNone/>
              <a:defRPr sz="2533"/>
            </a:lvl6pPr>
            <a:lvl7pPr marL="3474811" indent="0">
              <a:buNone/>
              <a:defRPr sz="2533"/>
            </a:lvl7pPr>
            <a:lvl8pPr marL="4053947" indent="0">
              <a:buNone/>
              <a:defRPr sz="2533"/>
            </a:lvl8pPr>
            <a:lvl9pPr marL="4633082" indent="0">
              <a:buNone/>
              <a:defRPr sz="25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06040"/>
            <a:ext cx="3932237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35" indent="0">
              <a:buNone/>
              <a:defRPr sz="1773"/>
            </a:lvl2pPr>
            <a:lvl3pPr marL="1158270" indent="0">
              <a:buNone/>
              <a:defRPr sz="1520"/>
            </a:lvl3pPr>
            <a:lvl4pPr marL="1737406" indent="0">
              <a:buNone/>
              <a:defRPr sz="1267"/>
            </a:lvl4pPr>
            <a:lvl5pPr marL="2316541" indent="0">
              <a:buNone/>
              <a:defRPr sz="1267"/>
            </a:lvl5pPr>
            <a:lvl6pPr marL="2895676" indent="0">
              <a:buNone/>
              <a:defRPr sz="1267"/>
            </a:lvl6pPr>
            <a:lvl7pPr marL="3474811" indent="0">
              <a:buNone/>
              <a:defRPr sz="1267"/>
            </a:lvl7pPr>
            <a:lvl8pPr marL="4053947" indent="0">
              <a:buNone/>
              <a:defRPr sz="1267"/>
            </a:lvl8pPr>
            <a:lvl9pPr marL="4633082" indent="0">
              <a:buNone/>
              <a:defRPr sz="1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96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62494"/>
            <a:ext cx="10515600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12458"/>
            <a:ext cx="10515600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051378"/>
            <a:ext cx="27432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94309-0BE5-40F5-9906-234B5A36C5ED}" type="datetimeFigureOut">
              <a:rPr lang="en-US" smtClean="0"/>
              <a:t>9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051378"/>
            <a:ext cx="41148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051378"/>
            <a:ext cx="27432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16B62-9060-4DB1-91DE-43391629F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989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58270" rtl="0" eaLnBrk="1" latinLnBrk="0" hangingPunct="1">
        <a:lnSpc>
          <a:spcPct val="90000"/>
        </a:lnSpc>
        <a:spcBef>
          <a:spcPct val="0"/>
        </a:spcBef>
        <a:buNone/>
        <a:defRPr sz="55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9568" indent="-289568" algn="l" defTabSz="1158270" rtl="0" eaLnBrk="1" latinLnBrk="0" hangingPunct="1">
        <a:lnSpc>
          <a:spcPct val="90000"/>
        </a:lnSpc>
        <a:spcBef>
          <a:spcPts val="1267"/>
        </a:spcBef>
        <a:buFont typeface="Arial" panose="020B0604020202020204" pitchFamily="34" charset="0"/>
        <a:buChar char="•"/>
        <a:defRPr sz="3547" kern="1200">
          <a:solidFill>
            <a:schemeClr val="tx1"/>
          </a:solidFill>
          <a:latin typeface="+mn-lt"/>
          <a:ea typeface="+mn-ea"/>
          <a:cs typeface="+mn-cs"/>
        </a:defRPr>
      </a:lvl1pPr>
      <a:lvl2pPr marL="868703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3040" kern="1200">
          <a:solidFill>
            <a:schemeClr val="tx1"/>
          </a:solidFill>
          <a:latin typeface="+mn-lt"/>
          <a:ea typeface="+mn-ea"/>
          <a:cs typeface="+mn-cs"/>
        </a:defRPr>
      </a:lvl2pPr>
      <a:lvl3pPr marL="1447838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533" kern="1200">
          <a:solidFill>
            <a:schemeClr val="tx1"/>
          </a:solidFill>
          <a:latin typeface="+mn-lt"/>
          <a:ea typeface="+mn-ea"/>
          <a:cs typeface="+mn-cs"/>
        </a:defRPr>
      </a:lvl3pPr>
      <a:lvl4pPr marL="2026973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606109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3185244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764379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343514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922650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1pPr>
      <a:lvl2pPr marL="579135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2pPr>
      <a:lvl3pPr marL="1158270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3pPr>
      <a:lvl4pPr marL="1737406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316541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2895676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474811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053947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633082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9.sv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8.png"/><Relationship Id="rId4" Type="http://schemas.openxmlformats.org/officeDocument/2006/relationships/image" Target="../media/image4.emf"/><Relationship Id="rId9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9.emf"/><Relationship Id="rId3" Type="http://schemas.openxmlformats.org/officeDocument/2006/relationships/oleObject" Target="../embeddings/oleObject9.bin"/><Relationship Id="rId7" Type="http://schemas.openxmlformats.org/officeDocument/2006/relationships/image" Target="../media/image17.png"/><Relationship Id="rId12" Type="http://schemas.openxmlformats.org/officeDocument/2006/relationships/oleObject" Target="../embeddings/oleObject12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11" Type="http://schemas.openxmlformats.org/officeDocument/2006/relationships/image" Target="../media/image18.emf"/><Relationship Id="rId5" Type="http://schemas.openxmlformats.org/officeDocument/2006/relationships/oleObject" Target="../embeddings/oleObject10.bin"/><Relationship Id="rId10" Type="http://schemas.openxmlformats.org/officeDocument/2006/relationships/oleObject" Target="../embeddings/oleObject11.bin"/><Relationship Id="rId4" Type="http://schemas.openxmlformats.org/officeDocument/2006/relationships/image" Target="../media/image15.emf"/><Relationship Id="rId9" Type="http://schemas.openxmlformats.org/officeDocument/2006/relationships/image" Target="../media/image9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13" Type="http://schemas.openxmlformats.org/officeDocument/2006/relationships/image" Target="../media/image27.emf"/><Relationship Id="rId18" Type="http://schemas.openxmlformats.org/officeDocument/2006/relationships/image" Target="../media/image30.png"/><Relationship Id="rId3" Type="http://schemas.openxmlformats.org/officeDocument/2006/relationships/oleObject" Target="../embeddings/oleObject13.bin"/><Relationship Id="rId21" Type="http://schemas.microsoft.com/office/2007/relationships/hdphoto" Target="../media/hdphoto3.wdp"/><Relationship Id="rId7" Type="http://schemas.openxmlformats.org/officeDocument/2006/relationships/image" Target="../media/image9.svg"/><Relationship Id="rId12" Type="http://schemas.openxmlformats.org/officeDocument/2006/relationships/oleObject" Target="../embeddings/oleObject16.bin"/><Relationship Id="rId17" Type="http://schemas.microsoft.com/office/2007/relationships/hdphoto" Target="../media/hdphoto1.wdp"/><Relationship Id="rId25" Type="http://schemas.microsoft.com/office/2007/relationships/hdphoto" Target="../media/hdphoto5.wdp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29.png"/><Relationship Id="rId20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26.emf"/><Relationship Id="rId24" Type="http://schemas.openxmlformats.org/officeDocument/2006/relationships/image" Target="../media/image33.png"/><Relationship Id="rId5" Type="http://schemas.openxmlformats.org/officeDocument/2006/relationships/image" Target="../media/image7.jpeg"/><Relationship Id="rId15" Type="http://schemas.openxmlformats.org/officeDocument/2006/relationships/image" Target="../media/image28.emf"/><Relationship Id="rId23" Type="http://schemas.microsoft.com/office/2007/relationships/hdphoto" Target="../media/hdphoto4.wdp"/><Relationship Id="rId10" Type="http://schemas.openxmlformats.org/officeDocument/2006/relationships/oleObject" Target="../embeddings/oleObject15.bin"/><Relationship Id="rId19" Type="http://schemas.microsoft.com/office/2007/relationships/hdphoto" Target="../media/hdphoto2.wdp"/><Relationship Id="rId4" Type="http://schemas.openxmlformats.org/officeDocument/2006/relationships/image" Target="../media/image24.emf"/><Relationship Id="rId9" Type="http://schemas.openxmlformats.org/officeDocument/2006/relationships/image" Target="../media/image25.emf"/><Relationship Id="rId14" Type="http://schemas.openxmlformats.org/officeDocument/2006/relationships/oleObject" Target="../embeddings/oleObject17.bin"/><Relationship Id="rId22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088DF8B-00F1-826E-7DB4-622F3B5E5BE5}"/>
              </a:ext>
            </a:extLst>
          </p:cNvPr>
          <p:cNvGrpSpPr/>
          <p:nvPr/>
        </p:nvGrpSpPr>
        <p:grpSpPr>
          <a:xfrm>
            <a:off x="27628" y="209540"/>
            <a:ext cx="6244673" cy="5559743"/>
            <a:chOff x="27628" y="209540"/>
            <a:chExt cx="6244673" cy="5559743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1404FFE-59F3-B498-2948-4A2C857967FC}"/>
                </a:ext>
              </a:extLst>
            </p:cNvPr>
            <p:cNvGrpSpPr/>
            <p:nvPr/>
          </p:nvGrpSpPr>
          <p:grpSpPr>
            <a:xfrm>
              <a:off x="576270" y="313086"/>
              <a:ext cx="5696031" cy="1580938"/>
              <a:chOff x="1991132" y="2277672"/>
              <a:chExt cx="5696031" cy="1580938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B9324226-BC45-0D34-6DD3-589F18D4DA2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991132" y="2277672"/>
                <a:ext cx="5696031" cy="1580938"/>
                <a:chOff x="3035290" y="3428217"/>
                <a:chExt cx="7650853" cy="2123499"/>
              </a:xfrm>
            </p:grpSpPr>
            <p:pic>
              <p:nvPicPr>
                <p:cNvPr id="3" name="Picture 2" descr="A picture containing screenshot&#10;&#10;Description automatically generated">
                  <a:extLst>
                    <a:ext uri="{FF2B5EF4-FFF2-40B4-BE49-F238E27FC236}">
                      <a16:creationId xmlns:a16="http://schemas.microsoft.com/office/drawing/2014/main" id="{BFE6482D-CA07-33D8-3D54-465AF86587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515332" y="3428217"/>
                  <a:ext cx="6170811" cy="1174233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3E8DFBD6-1D24-C748-C439-2F2F57240BCF}"/>
                    </a:ext>
                  </a:extLst>
                </p:cNvPr>
                <p:cNvSpPr txBox="1"/>
                <p:nvPr/>
              </p:nvSpPr>
              <p:spPr>
                <a:xfrm>
                  <a:off x="3441259" y="5138313"/>
                  <a:ext cx="1897338" cy="4134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WT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AP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2771582-6431-B56D-2B2C-94648D76D04B}"/>
                    </a:ext>
                  </a:extLst>
                </p:cNvPr>
                <p:cNvSpPr txBox="1"/>
                <p:nvPr/>
              </p:nvSpPr>
              <p:spPr>
                <a:xfrm>
                  <a:off x="3035290" y="4059834"/>
                  <a:ext cx="2543623" cy="4134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Strep-R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AP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EC85AD69-7173-D7CA-45BD-376C30D5DA90}"/>
                  </a:ext>
                </a:extLst>
              </p:cNvPr>
              <p:cNvSpPr/>
              <p:nvPr/>
            </p:nvSpPr>
            <p:spPr>
              <a:xfrm>
                <a:off x="5176457" y="2697346"/>
                <a:ext cx="259080" cy="137160"/>
              </a:xfrm>
              <a:prstGeom prst="rect">
                <a:avLst/>
              </a:prstGeom>
              <a:noFill/>
              <a:ln w="38100">
                <a:solidFill>
                  <a:srgbClr val="3BE93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503B659-1897-7739-EDFD-37608E036438}"/>
                </a:ext>
              </a:extLst>
            </p:cNvPr>
            <p:cNvSpPr txBox="1"/>
            <p:nvPr/>
          </p:nvSpPr>
          <p:spPr>
            <a:xfrm>
              <a:off x="27628" y="209540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642ADB0-89E1-4714-B306-A75783905BE8}"/>
                </a:ext>
              </a:extLst>
            </p:cNvPr>
            <p:cNvSpPr txBox="1"/>
            <p:nvPr/>
          </p:nvSpPr>
          <p:spPr>
            <a:xfrm>
              <a:off x="27628" y="2621476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849FB3AD-427E-ECD3-595D-F119EBE3114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6269" y="2945374"/>
              <a:ext cx="4316986" cy="2823909"/>
              <a:chOff x="7317560" y="3370840"/>
              <a:chExt cx="4199798" cy="2913674"/>
            </a:xfrm>
          </p:grpSpPr>
          <p:pic>
            <p:nvPicPr>
              <p:cNvPr id="24" name="Picture 23" descr="A picture containing cup, table, Petri dish, indoor&#10;&#10;Description automatically generated">
                <a:extLst>
                  <a:ext uri="{FF2B5EF4-FFF2-40B4-BE49-F238E27FC236}">
                    <a16:creationId xmlns:a16="http://schemas.microsoft.com/office/drawing/2014/main" id="{F5B31D2D-68DC-5F82-D642-D3E7CA333A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389533" y="3370840"/>
                <a:ext cx="1827362" cy="2596114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D286DF7-A139-365B-89C2-48706989986E}"/>
                  </a:ext>
                </a:extLst>
              </p:cNvPr>
              <p:cNvSpPr txBox="1"/>
              <p:nvPr/>
            </p:nvSpPr>
            <p:spPr>
              <a:xfrm>
                <a:off x="8137677" y="5966954"/>
                <a:ext cx="3379681" cy="3175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7H10 + streptomycin (50</a:t>
                </a:r>
                <a:r>
                  <a:rPr lang="el-G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/mL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7ABA863-3AF9-1E6D-2B0F-5437D383C10B}"/>
                  </a:ext>
                </a:extLst>
              </p:cNvPr>
              <p:cNvSpPr txBox="1"/>
              <p:nvPr/>
            </p:nvSpPr>
            <p:spPr>
              <a:xfrm>
                <a:off x="7317560" y="3626156"/>
                <a:ext cx="1295172" cy="3175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trep-R 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2F1A39C0-9DA4-BF0C-7373-BFF2BE9A4061}"/>
                  </a:ext>
                </a:extLst>
              </p:cNvPr>
              <p:cNvSpPr txBox="1"/>
              <p:nvPr/>
            </p:nvSpPr>
            <p:spPr>
              <a:xfrm>
                <a:off x="7611597" y="4833528"/>
                <a:ext cx="1223552" cy="3175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WT 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pic>
          <p:nvPicPr>
            <p:cNvPr id="63" name="Picture 62" descr="A picture containing screenshot&#10;&#10;Description automatically generated">
              <a:extLst>
                <a:ext uri="{FF2B5EF4-FFF2-40B4-BE49-F238E27FC236}">
                  <a16:creationId xmlns:a16="http://schemas.microsoft.com/office/drawing/2014/main" id="{1BF0C44D-3BA5-B060-6EC1-4B7F71D4EC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78153" y="1187300"/>
              <a:ext cx="4594148" cy="1227864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DF8F94A0-F771-B2DD-7CED-BBC900F9FE71}"/>
              </a:ext>
            </a:extLst>
          </p:cNvPr>
          <p:cNvSpPr txBox="1"/>
          <p:nvPr/>
        </p:nvSpPr>
        <p:spPr>
          <a:xfrm>
            <a:off x="27630" y="5885419"/>
            <a:ext cx="12025871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Generation of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Oligo-mediated recombineering was employed to generate a K43R mutation in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which is known to confer resistance to streptomycin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sequence of the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gene of wildtype (WT)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was generated by Sanger sequencing. Amino acids 40-46 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are visualized on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Geneiou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Prime and the point mutation in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is highlighted by a green box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WT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strains were plated on 7H10 agar with streptomycin to compare growth. </a:t>
            </a:r>
          </a:p>
        </p:txBody>
      </p:sp>
    </p:spTree>
    <p:extLst>
      <p:ext uri="{BB962C8B-B14F-4D97-AF65-F5344CB8AC3E}">
        <p14:creationId xmlns:p14="http://schemas.microsoft.com/office/powerpoint/2010/main" val="863038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1A1D30C-3264-EC00-79DF-C96F0A32EF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8098770"/>
              </p:ext>
            </p:extLst>
          </p:nvPr>
        </p:nvGraphicFramePr>
        <p:xfrm>
          <a:off x="854755" y="528827"/>
          <a:ext cx="9563243" cy="47174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05622">
                  <a:extLst>
                    <a:ext uri="{9D8B030D-6E8A-4147-A177-3AD203B41FA5}">
                      <a16:colId xmlns:a16="http://schemas.microsoft.com/office/drawing/2014/main" val="2257420026"/>
                    </a:ext>
                  </a:extLst>
                </a:gridCol>
                <a:gridCol w="3770616">
                  <a:extLst>
                    <a:ext uri="{9D8B030D-6E8A-4147-A177-3AD203B41FA5}">
                      <a16:colId xmlns:a16="http://schemas.microsoft.com/office/drawing/2014/main" val="2593864891"/>
                    </a:ext>
                  </a:extLst>
                </a:gridCol>
                <a:gridCol w="4187005">
                  <a:extLst>
                    <a:ext uri="{9D8B030D-6E8A-4147-A177-3AD203B41FA5}">
                      <a16:colId xmlns:a16="http://schemas.microsoft.com/office/drawing/2014/main" val="1836860236"/>
                    </a:ext>
                  </a:extLst>
                </a:gridCol>
              </a:tblGrid>
              <a:tr h="328298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Nam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Sequenc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Function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05098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Kan_F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AAGCCACGTTGTGTCTCA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presence of 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Nit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plasmi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9349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Kan_R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TCCGACTCGTCCAACAT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presence of 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Nit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plasmi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4654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P_rpsL_K43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GCGGGCGACCTTCCGAAGCGCCGAGTTCGGCTTCCTCGGGGTGGTGGTGTACACGCGGGTGCATACGC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generate strep-R 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P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75316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H_rpsL_K43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CGCGGGCGACCTTCCGAAGCGCCGAGTTCGGCTTCCTCGGGGTGGTGGTGTACACGCGGGTGCATACGC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generate strep-R 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H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24063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bovis_rpsL_K43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CGCGGGCAACCTTCCGAAGCGCCGAGTTCGGCTTCCTCGGAGTGGTGGTGTACACGCGGGTGCATACAC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generate strep-R 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.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bovis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70669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CrpsL_F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CAAGATCGGCAAGGTCAA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ps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K43R mutation by Sanger sequenc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23006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CrpsL_R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GATGATCTTGTACCGCACA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ps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K43R mutation by Sanger sequenc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13265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effectLst/>
                          <a:latin typeface="+mn-lt"/>
                        </a:rPr>
                        <a:t>MTBCrpsL_F</a:t>
                      </a:r>
                      <a:endParaRPr lang="en-US" sz="1400" b="0" i="0" u="none" strike="noStrike" dirty="0">
                        <a:effectLst/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GCCGACAAACAGAACGT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ps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K43R mutation by Sanger sequenc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978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effectLst/>
                          <a:latin typeface="+mn-lt"/>
                        </a:rPr>
                        <a:t>MTBCrpsL_R</a:t>
                      </a:r>
                      <a:endParaRPr lang="en-US" sz="1400" b="0" i="0" u="none" strike="noStrike" dirty="0">
                        <a:effectLst/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GTGACCAACTGCGATCCGTA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confirm </a:t>
                      </a:r>
                      <a:r>
                        <a:rPr lang="en-US" sz="1400" i="1" dirty="0" err="1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ps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K43R mutation by Sanger sequenc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90874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F57_F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TACCGAATGTTGTTGTCACC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test for fecal shedding of 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P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49934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F57_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effectLst/>
                          <a:latin typeface="+mn-lt"/>
                        </a:rPr>
                        <a:t>TGGCACAGACGACCATTCAA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o test for fecal shedding of </a:t>
                      </a:r>
                      <a:r>
                        <a:rPr lang="en-US" sz="1400" i="1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MAP</a:t>
                      </a:r>
                      <a:endParaRPr lang="en-US" sz="14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804837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53E584A-6A3C-82F7-DF0B-3D1A535CA252}"/>
              </a:ext>
            </a:extLst>
          </p:cNvPr>
          <p:cNvSpPr txBox="1"/>
          <p:nvPr/>
        </p:nvSpPr>
        <p:spPr>
          <a:xfrm>
            <a:off x="805766" y="126839"/>
            <a:ext cx="60987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Table 1: </a:t>
            </a:r>
            <a:r>
              <a:rPr lang="en-US" sz="1400" dirty="0"/>
              <a:t>Primer and oligo sequence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69583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EE60EEDB-58E3-EFBA-49B1-E3A51FEB1E97}"/>
              </a:ext>
            </a:extLst>
          </p:cNvPr>
          <p:cNvGrpSpPr/>
          <p:nvPr/>
        </p:nvGrpSpPr>
        <p:grpSpPr>
          <a:xfrm>
            <a:off x="65218" y="192533"/>
            <a:ext cx="12045505" cy="3903295"/>
            <a:chOff x="65218" y="192533"/>
            <a:chExt cx="12045505" cy="3903295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D1286B90-2E06-5E78-2DD9-CB09971E531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63813978"/>
                </p:ext>
              </p:extLst>
            </p:nvPr>
          </p:nvGraphicFramePr>
          <p:xfrm>
            <a:off x="179544" y="1354215"/>
            <a:ext cx="4006851" cy="2741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4006510" imgH="2742119" progId="Prism9.Document">
                    <p:embed/>
                  </p:oleObj>
                </mc:Choice>
                <mc:Fallback>
                  <p:oleObj name="Prism 9" r:id="rId3" imgW="4006510" imgH="2742119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D1286B90-2E06-5E78-2DD9-CB09971E531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9544" y="1354215"/>
                          <a:ext cx="4006851" cy="2741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4E5CD7E2-74B2-A288-DF72-56D4C7B5CD7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88279075"/>
                </p:ext>
              </p:extLst>
            </p:nvPr>
          </p:nvGraphicFramePr>
          <p:xfrm>
            <a:off x="4280497" y="1339436"/>
            <a:ext cx="3867150" cy="2741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866417" imgH="2742119" progId="Prism9.Document">
                    <p:embed/>
                  </p:oleObj>
                </mc:Choice>
                <mc:Fallback>
                  <p:oleObj name="Prism 9" r:id="rId5" imgW="3866417" imgH="2742119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4E5CD7E2-74B2-A288-DF72-56D4C7B5CD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280497" y="1339436"/>
                          <a:ext cx="3867150" cy="2741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CDCEA49F-613D-4182-B31D-5336193E19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4018534"/>
                </p:ext>
              </p:extLst>
            </p:nvPr>
          </p:nvGraphicFramePr>
          <p:xfrm>
            <a:off x="8202900" y="1339437"/>
            <a:ext cx="3751262" cy="2741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751894" imgH="2742119" progId="Prism9.Document">
                    <p:embed/>
                  </p:oleObj>
                </mc:Choice>
                <mc:Fallback>
                  <p:oleObj name="Prism 9" r:id="rId7" imgW="3751894" imgH="2742119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CDCEA49F-613D-4182-B31D-5336193E190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202900" y="1339437"/>
                          <a:ext cx="3751262" cy="2741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803694D3-4B2C-0F4B-2272-E11212A4E2A1}"/>
                </a:ext>
              </a:extLst>
            </p:cNvPr>
            <p:cNvGrpSpPr/>
            <p:nvPr/>
          </p:nvGrpSpPr>
          <p:grpSpPr>
            <a:xfrm>
              <a:off x="490242" y="273450"/>
              <a:ext cx="7924099" cy="1118069"/>
              <a:chOff x="512893" y="1938462"/>
              <a:chExt cx="7924099" cy="1118069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FD6B59E-338B-9FAC-791A-4B51152B5A5A}"/>
                  </a:ext>
                </a:extLst>
              </p:cNvPr>
              <p:cNvSpPr txBox="1"/>
              <p:nvPr/>
            </p:nvSpPr>
            <p:spPr>
              <a:xfrm>
                <a:off x="512893" y="1940133"/>
                <a:ext cx="18838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0mg streptomycin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B4ED5B2-4A03-5F7F-7F04-9523512416E8}"/>
                  </a:ext>
                </a:extLst>
              </p:cNvPr>
              <p:cNvSpPr txBox="1"/>
              <p:nvPr/>
            </p:nvSpPr>
            <p:spPr>
              <a:xfrm>
                <a:off x="2203588" y="2498086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5BF1CF95-678A-DD5D-EE92-2B95DA6DD6AD}"/>
                  </a:ext>
                </a:extLst>
              </p:cNvPr>
              <p:cNvSpPr txBox="1"/>
              <p:nvPr/>
            </p:nvSpPr>
            <p:spPr>
              <a:xfrm>
                <a:off x="2693918" y="1940133"/>
                <a:ext cx="1714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65C55E9-6E20-F468-69B9-63C800D637E9}"/>
                  </a:ext>
                </a:extLst>
              </p:cNvPr>
              <p:cNvSpPr txBox="1"/>
              <p:nvPr/>
            </p:nvSpPr>
            <p:spPr>
              <a:xfrm>
                <a:off x="7231380" y="2247910"/>
                <a:ext cx="120561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acrifice</a:t>
                </a:r>
              </a:p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Collect organs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71616CE-663A-A016-2D85-1759555E1774}"/>
                  </a:ext>
                </a:extLst>
              </p:cNvPr>
              <p:cNvSpPr txBox="1"/>
              <p:nvPr/>
            </p:nvSpPr>
            <p:spPr>
              <a:xfrm>
                <a:off x="935331" y="2794921"/>
                <a:ext cx="8405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C57BL/6</a:t>
                </a:r>
              </a:p>
            </p:txBody>
          </p: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A1355D77-FFF0-86F8-E762-A7B49AD2183B}"/>
                  </a:ext>
                </a:extLst>
              </p:cNvPr>
              <p:cNvGrpSpPr/>
              <p:nvPr/>
            </p:nvGrpSpPr>
            <p:grpSpPr>
              <a:xfrm>
                <a:off x="2863550" y="2211140"/>
                <a:ext cx="1332654" cy="660423"/>
                <a:chOff x="3650950" y="562542"/>
                <a:chExt cx="1332654" cy="660423"/>
              </a:xfrm>
            </p:grpSpPr>
            <p:pic>
              <p:nvPicPr>
                <p:cNvPr id="46" name="Picture 6" descr="Image result for mouse clipart science">
                  <a:extLst>
                    <a:ext uri="{FF2B5EF4-FFF2-40B4-BE49-F238E27FC236}">
                      <a16:creationId xmlns:a16="http://schemas.microsoft.com/office/drawing/2014/main" id="{9C8C14C0-7899-89F8-3476-46F3A75A937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50950" y="562542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7" name="Graphic 46" descr="Needle">
                  <a:extLst>
                    <a:ext uri="{FF2B5EF4-FFF2-40B4-BE49-F238E27FC236}">
                      <a16:creationId xmlns:a16="http://schemas.microsoft.com/office/drawing/2014/main" id="{C19F8A6C-BA23-24E4-175D-5014D0A1DAA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11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6758" y="623271"/>
                  <a:ext cx="226846" cy="194835"/>
                </a:xfrm>
                <a:prstGeom prst="rect">
                  <a:avLst/>
                </a:prstGeom>
              </p:spPr>
            </p:pic>
          </p:grp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29D840D6-DA45-75DC-478D-445C54069C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27713" y="2509520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3227C717-EBF9-D671-3328-EAFDFC301E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1783" y="2509520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BB407F0A-44C5-FED4-1434-6CA9EDBA97B0}"/>
                  </a:ext>
                </a:extLst>
              </p:cNvPr>
              <p:cNvGrpSpPr/>
              <p:nvPr/>
            </p:nvGrpSpPr>
            <p:grpSpPr>
              <a:xfrm>
                <a:off x="805568" y="2211140"/>
                <a:ext cx="1332654" cy="660423"/>
                <a:chOff x="1592968" y="528898"/>
                <a:chExt cx="1332654" cy="660423"/>
              </a:xfrm>
            </p:grpSpPr>
            <p:pic>
              <p:nvPicPr>
                <p:cNvPr id="44" name="Picture 6" descr="Image result for mouse clipart science">
                  <a:extLst>
                    <a:ext uri="{FF2B5EF4-FFF2-40B4-BE49-F238E27FC236}">
                      <a16:creationId xmlns:a16="http://schemas.microsoft.com/office/drawing/2014/main" id="{92EAB6C8-BB36-12E5-04B4-5DFB64DC2B7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592968" y="528898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" name="Graphic 44" descr="Needle">
                  <a:extLst>
                    <a:ext uri="{FF2B5EF4-FFF2-40B4-BE49-F238E27FC236}">
                      <a16:creationId xmlns:a16="http://schemas.microsoft.com/office/drawing/2014/main" id="{E2AED9F4-C3BD-6219-34CA-E817DFF7D8A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11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8776" y="589627"/>
                  <a:ext cx="226846" cy="194835"/>
                </a:xfrm>
                <a:prstGeom prst="rect">
                  <a:avLst/>
                </a:prstGeom>
              </p:spPr>
            </p:pic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E64369F-371E-5997-BE98-6C3FA9D205FA}"/>
                  </a:ext>
                </a:extLst>
              </p:cNvPr>
              <p:cNvSpPr txBox="1"/>
              <p:nvPr/>
            </p:nvSpPr>
            <p:spPr>
              <a:xfrm>
                <a:off x="4261835" y="2496415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D3FA8E3-4720-223B-3F16-6EACCD91481F}"/>
                  </a:ext>
                </a:extLst>
              </p:cNvPr>
              <p:cNvSpPr txBox="1"/>
              <p:nvPr/>
            </p:nvSpPr>
            <p:spPr>
              <a:xfrm>
                <a:off x="4752165" y="1938462"/>
                <a:ext cx="1714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0A773D78-E843-4F64-EED7-E88DACDFBA31}"/>
                  </a:ext>
                </a:extLst>
              </p:cNvPr>
              <p:cNvGrpSpPr/>
              <p:nvPr/>
            </p:nvGrpSpPr>
            <p:grpSpPr>
              <a:xfrm>
                <a:off x="4921797" y="2209469"/>
                <a:ext cx="1332654" cy="660423"/>
                <a:chOff x="3650950" y="562542"/>
                <a:chExt cx="1332654" cy="660423"/>
              </a:xfrm>
            </p:grpSpPr>
            <p:pic>
              <p:nvPicPr>
                <p:cNvPr id="42" name="Picture 6" descr="Image result for mouse clipart science">
                  <a:extLst>
                    <a:ext uri="{FF2B5EF4-FFF2-40B4-BE49-F238E27FC236}">
                      <a16:creationId xmlns:a16="http://schemas.microsoft.com/office/drawing/2014/main" id="{3778981B-80BA-9386-6E85-F2089661D40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50950" y="562542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3" name="Graphic 42" descr="Needle">
                  <a:extLst>
                    <a:ext uri="{FF2B5EF4-FFF2-40B4-BE49-F238E27FC236}">
                      <a16:creationId xmlns:a16="http://schemas.microsoft.com/office/drawing/2014/main" id="{2A6AD99F-A75B-DD64-2E72-DCC077A154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11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6758" y="623271"/>
                  <a:ext cx="226846" cy="194835"/>
                </a:xfrm>
                <a:prstGeom prst="rect">
                  <a:avLst/>
                </a:prstGeom>
              </p:spPr>
            </p:pic>
          </p:grp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id="{79CAC038-C4B9-C421-1460-A9FEBEA8A2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20030" y="2507849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290A9F2-9AE8-B42F-ABA1-17E944650B9E}"/>
                </a:ext>
              </a:extLst>
            </p:cNvPr>
            <p:cNvSpPr txBox="1"/>
            <p:nvPr/>
          </p:nvSpPr>
          <p:spPr>
            <a:xfrm>
              <a:off x="65218" y="192533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318F109-713C-5994-5AE5-60EA6D2080A7}"/>
                </a:ext>
              </a:extLst>
            </p:cNvPr>
            <p:cNvSpPr txBox="1"/>
            <p:nvPr/>
          </p:nvSpPr>
          <p:spPr>
            <a:xfrm>
              <a:off x="85438" y="1342332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FDE1FB5-F546-01D0-799D-EAE33D5F0166}"/>
                </a:ext>
              </a:extLst>
            </p:cNvPr>
            <p:cNvSpPr txBox="1"/>
            <p:nvPr/>
          </p:nvSpPr>
          <p:spPr>
            <a:xfrm>
              <a:off x="4010523" y="1341107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F88D67E-917D-3DEE-B8AB-48BC02BB2956}"/>
                </a:ext>
              </a:extLst>
            </p:cNvPr>
            <p:cNvSpPr txBox="1"/>
            <p:nvPr/>
          </p:nvSpPr>
          <p:spPr>
            <a:xfrm>
              <a:off x="7720153" y="1339435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F3DFDC6-4152-8514-7757-43082AF83FF0}"/>
                </a:ext>
              </a:extLst>
            </p:cNvPr>
            <p:cNvSpPr txBox="1"/>
            <p:nvPr/>
          </p:nvSpPr>
          <p:spPr>
            <a:xfrm>
              <a:off x="3659091" y="3338598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9232D5C-EE01-F02E-D6D3-B54C7C640165}"/>
                </a:ext>
              </a:extLst>
            </p:cNvPr>
            <p:cNvSpPr txBox="1"/>
            <p:nvPr/>
          </p:nvSpPr>
          <p:spPr>
            <a:xfrm>
              <a:off x="7635922" y="3357040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482E13A-6727-2E9B-CAF7-C6D88CB8D5AA}"/>
                </a:ext>
              </a:extLst>
            </p:cNvPr>
            <p:cNvSpPr txBox="1"/>
            <p:nvPr/>
          </p:nvSpPr>
          <p:spPr>
            <a:xfrm>
              <a:off x="11410142" y="3316296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3C702EC-C883-A0B8-1CCE-BDACFB103689}"/>
                </a:ext>
              </a:extLst>
            </p:cNvPr>
            <p:cNvSpPr txBox="1"/>
            <p:nvPr/>
          </p:nvSpPr>
          <p:spPr>
            <a:xfrm>
              <a:off x="6117457" y="809789"/>
              <a:ext cx="120561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48 hrs</a:t>
              </a:r>
            </a:p>
            <a:p>
              <a:pPr algn="ctr"/>
              <a:r>
                <a:rPr lang="en-CA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4, 8 , 12, 24 </a:t>
              </a:r>
              <a:r>
                <a:rPr lang="en-CA" sz="11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wks</a:t>
              </a:r>
              <a:endParaRPr lang="en-CA" sz="11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525578D9-3091-B458-2E22-718E92BB64FF}"/>
              </a:ext>
            </a:extLst>
          </p:cNvPr>
          <p:cNvSpPr txBox="1"/>
          <p:nvPr/>
        </p:nvSpPr>
        <p:spPr>
          <a:xfrm>
            <a:off x="57778" y="4179810"/>
            <a:ext cx="1205294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Dissemination of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57BL/6 mice were given 20mg of streptomycin followed by 2 consecutive doses of 10</a:t>
            </a: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CFU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each 24-hours apart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-D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Dissemination 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into the spleen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liver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and lungs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was evaluated at 48-hours, 4-, 8-, 12-, and 24-weeks post-gavage.</a:t>
            </a:r>
          </a:p>
        </p:txBody>
      </p:sp>
    </p:spTree>
    <p:extLst>
      <p:ext uri="{BB962C8B-B14F-4D97-AF65-F5344CB8AC3E}">
        <p14:creationId xmlns:p14="http://schemas.microsoft.com/office/powerpoint/2010/main" val="2940544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3BF3292-0976-7369-E06C-1BF2ABBF9495}"/>
              </a:ext>
            </a:extLst>
          </p:cNvPr>
          <p:cNvGrpSpPr/>
          <p:nvPr/>
        </p:nvGrpSpPr>
        <p:grpSpPr>
          <a:xfrm>
            <a:off x="65218" y="36883"/>
            <a:ext cx="7165847" cy="3578227"/>
            <a:chOff x="65218" y="36883"/>
            <a:chExt cx="7165847" cy="3578227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290A9F2-9AE8-B42F-ABA1-17E944650B9E}"/>
                </a:ext>
              </a:extLst>
            </p:cNvPr>
            <p:cNvSpPr txBox="1"/>
            <p:nvPr/>
          </p:nvSpPr>
          <p:spPr>
            <a:xfrm>
              <a:off x="65218" y="36883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FE035425-6239-9421-C501-8643285214D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34339625"/>
                </p:ext>
              </p:extLst>
            </p:nvPr>
          </p:nvGraphicFramePr>
          <p:xfrm>
            <a:off x="339538" y="36885"/>
            <a:ext cx="3797300" cy="2998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797631" imgH="2999553" progId="Prism9.Document">
                    <p:embed/>
                  </p:oleObj>
                </mc:Choice>
                <mc:Fallback>
                  <p:oleObj name="Prism 9" r:id="rId3" imgW="3797631" imgH="2999553" progId="Prism9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FE035425-6239-9421-C501-8643285214D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39538" y="36885"/>
                          <a:ext cx="3797300" cy="2998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6CEABA6C-919A-0C7D-9AD6-FE3179CB792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333058"/>
                </p:ext>
              </p:extLst>
            </p:nvPr>
          </p:nvGraphicFramePr>
          <p:xfrm>
            <a:off x="4959352" y="189285"/>
            <a:ext cx="2271713" cy="3425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271736" imgH="3426569" progId="Prism9.Document">
                    <p:embed/>
                  </p:oleObj>
                </mc:Choice>
                <mc:Fallback>
                  <p:oleObj name="Prism 9" r:id="rId5" imgW="2271736" imgH="3426569" progId="Prism9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6CEABA6C-919A-0C7D-9AD6-FE3179CB792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959352" y="189285"/>
                          <a:ext cx="2271713" cy="3425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F6B06BE-7E99-0902-80B3-6790F54B8F1F}"/>
                </a:ext>
              </a:extLst>
            </p:cNvPr>
            <p:cNvSpPr txBox="1"/>
            <p:nvPr/>
          </p:nvSpPr>
          <p:spPr>
            <a:xfrm>
              <a:off x="4266630" y="36883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D41787D-3586-8BC8-B6F0-D745CBCF615A}"/>
              </a:ext>
            </a:extLst>
          </p:cNvPr>
          <p:cNvSpPr txBox="1"/>
          <p:nvPr/>
        </p:nvSpPr>
        <p:spPr>
          <a:xfrm>
            <a:off x="65218" y="3615108"/>
            <a:ext cx="1212678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Fecal shedding assessment</a:t>
            </a:r>
          </a:p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 standard curve was prepared for quantitative PCR of the F57 gene using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K10 genomic DNA diluted from 1x10</a:t>
            </a: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7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o 1 genome equivalents in order to interpolate values from fecal samples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Fecal shedding was assessed in uninfected controls and mice 12-weeks post-gavage with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.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30634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7E05469-9993-BEFF-3A89-5EA38CE9F8AF}"/>
              </a:ext>
            </a:extLst>
          </p:cNvPr>
          <p:cNvSpPr txBox="1"/>
          <p:nvPr/>
        </p:nvSpPr>
        <p:spPr>
          <a:xfrm>
            <a:off x="27630" y="2783907"/>
            <a:ext cx="12191999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Pooled organ CFUs of C57BL/6 and BALB/c mice at 12- and 24-weeks post-infection</a:t>
            </a:r>
          </a:p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organ CFUs of the large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small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and MLNs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were pooled from C57BL/6 and BALB/c mice and compared between 12- and 24-weeks post infection (*p&lt;0.05)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279C019-7E69-08C7-B07B-86EA9FD94857}"/>
              </a:ext>
            </a:extLst>
          </p:cNvPr>
          <p:cNvGrpSpPr/>
          <p:nvPr/>
        </p:nvGrpSpPr>
        <p:grpSpPr>
          <a:xfrm>
            <a:off x="27628" y="-73699"/>
            <a:ext cx="6847007" cy="2729147"/>
            <a:chOff x="27628" y="-73699"/>
            <a:chExt cx="6847007" cy="2729147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6E8EEC8-0F17-A5C3-DE97-129AD9D2B3E7}"/>
                </a:ext>
              </a:extLst>
            </p:cNvPr>
            <p:cNvGrpSpPr/>
            <p:nvPr/>
          </p:nvGrpSpPr>
          <p:grpSpPr>
            <a:xfrm>
              <a:off x="27628" y="-73699"/>
              <a:ext cx="6847007" cy="2729147"/>
              <a:chOff x="27628" y="-73699"/>
              <a:chExt cx="6847007" cy="2729147"/>
            </a:xfrm>
          </p:grpSpPr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DDBA0354-9898-7035-8F60-706E86A18CB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47752450"/>
                  </p:ext>
                </p:extLst>
              </p:nvPr>
            </p:nvGraphicFramePr>
            <p:xfrm>
              <a:off x="301627" y="121798"/>
              <a:ext cx="2239963" cy="25336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2468370" imgH="2793966" progId="Prism9.Document">
                      <p:embed/>
                    </p:oleObj>
                  </mc:Choice>
                  <mc:Fallback>
                    <p:oleObj name="Prism 9" r:id="rId3" imgW="2468370" imgH="2793966" progId="Prism9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DDBA0354-9898-7035-8F60-706E86A18CB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01627" y="121798"/>
                            <a:ext cx="2239963" cy="25336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AE36F0D8-FE5C-C1B8-28F7-C30C4049573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20833168"/>
                  </p:ext>
                </p:extLst>
              </p:nvPr>
            </p:nvGraphicFramePr>
            <p:xfrm>
              <a:off x="2470659" y="127953"/>
              <a:ext cx="2270689" cy="252238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2468370" imgH="2742119" progId="Prism9.Document">
                      <p:embed/>
                    </p:oleObj>
                  </mc:Choice>
                  <mc:Fallback>
                    <p:oleObj name="Prism 9" r:id="rId5" imgW="2468370" imgH="2742119" progId="Prism9.Document">
                      <p:embed/>
                      <p:pic>
                        <p:nvPicPr>
                          <p:cNvPr id="7" name="Object 6">
                            <a:extLst>
                              <a:ext uri="{FF2B5EF4-FFF2-40B4-BE49-F238E27FC236}">
                                <a16:creationId xmlns:a16="http://schemas.microsoft.com/office/drawing/2014/main" id="{AE36F0D8-FE5C-C1B8-28F7-C30C404957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470659" y="127953"/>
                            <a:ext cx="2270689" cy="252238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>
                <a:extLst>
                  <a:ext uri="{FF2B5EF4-FFF2-40B4-BE49-F238E27FC236}">
                    <a16:creationId xmlns:a16="http://schemas.microsoft.com/office/drawing/2014/main" id="{DF70A01E-9101-9D9D-B9B7-6F6AF9CD994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20778271"/>
                  </p:ext>
                </p:extLst>
              </p:nvPr>
            </p:nvGraphicFramePr>
            <p:xfrm>
              <a:off x="4771953" y="127951"/>
              <a:ext cx="2102682" cy="24906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2460807" imgH="2912781" progId="Prism9.Document">
                      <p:embed/>
                    </p:oleObj>
                  </mc:Choice>
                  <mc:Fallback>
                    <p:oleObj name="Prism 9" r:id="rId7" imgW="2460807" imgH="2912781" progId="Prism9.Document">
                      <p:embed/>
                      <p:pic>
                        <p:nvPicPr>
                          <p:cNvPr id="8" name="Object 7">
                            <a:extLst>
                              <a:ext uri="{FF2B5EF4-FFF2-40B4-BE49-F238E27FC236}">
                                <a16:creationId xmlns:a16="http://schemas.microsoft.com/office/drawing/2014/main" id="{DF70A01E-9101-9D9D-B9B7-6F6AF9CD994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771953" y="127951"/>
                            <a:ext cx="2102682" cy="24906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75B3776-1292-F88A-9668-45A426522E67}"/>
                  </a:ext>
                </a:extLst>
              </p:cNvPr>
              <p:cNvSpPr txBox="1"/>
              <p:nvPr/>
            </p:nvSpPr>
            <p:spPr>
              <a:xfrm>
                <a:off x="27628" y="-73699"/>
                <a:ext cx="54864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/>
                  <a:t>A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30CF539-73F2-64EE-FFB9-D2D989C26CA2}"/>
                  </a:ext>
                </a:extLst>
              </p:cNvPr>
              <p:cNvSpPr txBox="1"/>
              <p:nvPr/>
            </p:nvSpPr>
            <p:spPr>
              <a:xfrm>
                <a:off x="2443212" y="-37317"/>
                <a:ext cx="54864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/>
                  <a:t>B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FF298CE-D988-EE7D-AE05-CCA5E841BC1D}"/>
                  </a:ext>
                </a:extLst>
              </p:cNvPr>
              <p:cNvSpPr txBox="1"/>
              <p:nvPr/>
            </p:nvSpPr>
            <p:spPr>
              <a:xfrm>
                <a:off x="4667893" y="-37317"/>
                <a:ext cx="54864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/>
                  <a:t>C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284853C-7796-942A-F4B7-D5B44016D145}"/>
                </a:ext>
              </a:extLst>
            </p:cNvPr>
            <p:cNvSpPr txBox="1"/>
            <p:nvPr/>
          </p:nvSpPr>
          <p:spPr>
            <a:xfrm>
              <a:off x="2066140" y="1861846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1C503FC-B3DE-57C5-5E4F-F9E8B2C6E979}"/>
                </a:ext>
              </a:extLst>
            </p:cNvPr>
            <p:cNvSpPr txBox="1"/>
            <p:nvPr/>
          </p:nvSpPr>
          <p:spPr>
            <a:xfrm>
              <a:off x="4247204" y="1801686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667311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915E66A-F241-D8F5-4F0F-172CBA5EF94B}"/>
              </a:ext>
            </a:extLst>
          </p:cNvPr>
          <p:cNvGrpSpPr/>
          <p:nvPr/>
        </p:nvGrpSpPr>
        <p:grpSpPr>
          <a:xfrm>
            <a:off x="27628" y="52504"/>
            <a:ext cx="11120450" cy="7092331"/>
            <a:chOff x="27628" y="52504"/>
            <a:chExt cx="11120450" cy="7092331"/>
          </a:xfrm>
        </p:grpSpPr>
        <p:graphicFrame>
          <p:nvGraphicFramePr>
            <p:cNvPr id="65" name="Object 64">
              <a:extLst>
                <a:ext uri="{FF2B5EF4-FFF2-40B4-BE49-F238E27FC236}">
                  <a16:creationId xmlns:a16="http://schemas.microsoft.com/office/drawing/2014/main" id="{79D9C370-137F-BBFA-0825-B936080AD1E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3221954"/>
                </p:ext>
              </p:extLst>
            </p:nvPr>
          </p:nvGraphicFramePr>
          <p:xfrm>
            <a:off x="39707" y="3963154"/>
            <a:ext cx="3557109" cy="31816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4035681" imgH="3609473" progId="Prism9.Document">
                    <p:embed/>
                  </p:oleObj>
                </mc:Choice>
                <mc:Fallback>
                  <p:oleObj name="Prism 9" r:id="rId3" imgW="4035681" imgH="3609473" progId="Prism9.Document">
                    <p:embed/>
                    <p:pic>
                      <p:nvPicPr>
                        <p:cNvPr id="65" name="Object 64">
                          <a:extLst>
                            <a:ext uri="{FF2B5EF4-FFF2-40B4-BE49-F238E27FC236}">
                              <a16:creationId xmlns:a16="http://schemas.microsoft.com/office/drawing/2014/main" id="{79D9C370-137F-BBFA-0825-B936080AD1E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9707" y="3963154"/>
                          <a:ext cx="3557109" cy="318168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3" name="Object 62">
              <a:extLst>
                <a:ext uri="{FF2B5EF4-FFF2-40B4-BE49-F238E27FC236}">
                  <a16:creationId xmlns:a16="http://schemas.microsoft.com/office/drawing/2014/main" id="{84625549-EE33-8538-4AB7-C3A298678A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81500965"/>
                </p:ext>
              </p:extLst>
            </p:nvPr>
          </p:nvGraphicFramePr>
          <p:xfrm>
            <a:off x="7555566" y="1219551"/>
            <a:ext cx="3592512" cy="2797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4180455" imgH="3254106" progId="Prism9.Document">
                    <p:embed/>
                  </p:oleObj>
                </mc:Choice>
                <mc:Fallback>
                  <p:oleObj name="Prism 9" r:id="rId5" imgW="4180455" imgH="3254106" progId="Prism9.Document">
                    <p:embed/>
                    <p:pic>
                      <p:nvPicPr>
                        <p:cNvPr id="63" name="Object 62">
                          <a:extLst>
                            <a:ext uri="{FF2B5EF4-FFF2-40B4-BE49-F238E27FC236}">
                              <a16:creationId xmlns:a16="http://schemas.microsoft.com/office/drawing/2014/main" id="{84625549-EE33-8538-4AB7-C3A298678A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555566" y="1219551"/>
                          <a:ext cx="3592512" cy="2797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F2F6B13-D9C7-2DA9-3AA3-A20B4E487133}"/>
                </a:ext>
              </a:extLst>
            </p:cNvPr>
            <p:cNvSpPr txBox="1"/>
            <p:nvPr/>
          </p:nvSpPr>
          <p:spPr>
            <a:xfrm>
              <a:off x="27628" y="52504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CB53429-BE22-20E7-A262-2B348C3320F9}"/>
                </a:ext>
              </a:extLst>
            </p:cNvPr>
            <p:cNvGrpSpPr/>
            <p:nvPr/>
          </p:nvGrpSpPr>
          <p:grpSpPr>
            <a:xfrm>
              <a:off x="484320" y="211978"/>
              <a:ext cx="7924099" cy="1093058"/>
              <a:chOff x="484318" y="49337"/>
              <a:chExt cx="7924099" cy="1093058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364A7BF-5A84-3D92-572A-D9234B7D47B5}"/>
                  </a:ext>
                </a:extLst>
              </p:cNvPr>
              <p:cNvSpPr txBox="1"/>
              <p:nvPr/>
            </p:nvSpPr>
            <p:spPr>
              <a:xfrm>
                <a:off x="484318" y="51008"/>
                <a:ext cx="18838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+/- 20mg streptomycin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962C3565-7A55-CD3C-E22C-1EA8F025667A}"/>
                  </a:ext>
                </a:extLst>
              </p:cNvPr>
              <p:cNvSpPr txBox="1"/>
              <p:nvPr/>
            </p:nvSpPr>
            <p:spPr>
              <a:xfrm>
                <a:off x="2175013" y="608961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447D9F56-D020-4E04-A432-392F4301883A}"/>
                  </a:ext>
                </a:extLst>
              </p:cNvPr>
              <p:cNvSpPr txBox="1"/>
              <p:nvPr/>
            </p:nvSpPr>
            <p:spPr>
              <a:xfrm>
                <a:off x="2665343" y="51008"/>
                <a:ext cx="18838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1A182D8-8083-4602-2787-938E43B3D2A8}"/>
                  </a:ext>
                </a:extLst>
              </p:cNvPr>
              <p:cNvSpPr txBox="1"/>
              <p:nvPr/>
            </p:nvSpPr>
            <p:spPr>
              <a:xfrm>
                <a:off x="7202805" y="358785"/>
                <a:ext cx="120561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acrifice</a:t>
                </a:r>
              </a:p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Collect organs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7285AB4-636D-D33C-FC04-27FCE21FE6C0}"/>
                  </a:ext>
                </a:extLst>
              </p:cNvPr>
              <p:cNvSpPr txBox="1"/>
              <p:nvPr/>
            </p:nvSpPr>
            <p:spPr>
              <a:xfrm>
                <a:off x="948031" y="880785"/>
                <a:ext cx="8405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BALB/c</a:t>
                </a:r>
              </a:p>
            </p:txBody>
          </p: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F990B99E-C5A6-6172-1CD5-E8985CEA49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99138" y="620395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0C79C1F4-E2BB-70C1-D2BF-A7D89A6BF7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33208" y="620395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4A0E350-467D-364C-5D61-1A9AB474A507}"/>
                  </a:ext>
                </a:extLst>
              </p:cNvPr>
              <p:cNvSpPr txBox="1"/>
              <p:nvPr/>
            </p:nvSpPr>
            <p:spPr>
              <a:xfrm>
                <a:off x="4233260" y="607290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2D540C75-ABCF-7130-F049-310BBB079515}"/>
                  </a:ext>
                </a:extLst>
              </p:cNvPr>
              <p:cNvSpPr txBox="1"/>
              <p:nvPr/>
            </p:nvSpPr>
            <p:spPr>
              <a:xfrm>
                <a:off x="4723590" y="49337"/>
                <a:ext cx="18838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AP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30121688-E8AB-4C33-1BD2-C89508FFC7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1455" y="618724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565280AE-6AA3-BD49-84CA-523108E1DB85}"/>
                  </a:ext>
                </a:extLst>
              </p:cNvPr>
              <p:cNvGrpSpPr/>
              <p:nvPr/>
            </p:nvGrpSpPr>
            <p:grpSpPr>
              <a:xfrm>
                <a:off x="802589" y="357114"/>
                <a:ext cx="1298309" cy="609705"/>
                <a:chOff x="546930" y="254185"/>
                <a:chExt cx="1298309" cy="609705"/>
              </a:xfrm>
            </p:grpSpPr>
            <p:pic>
              <p:nvPicPr>
                <p:cNvPr id="47" name="Picture 10" descr="Laboratory mouse - Wikipedia">
                  <a:extLst>
                    <a:ext uri="{FF2B5EF4-FFF2-40B4-BE49-F238E27FC236}">
                      <a16:creationId xmlns:a16="http://schemas.microsoft.com/office/drawing/2014/main" id="{D798BEB6-A7E6-272E-9000-60BFD8E201A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546930" y="254185"/>
                  <a:ext cx="1104585" cy="6097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2" name="Graphic 41" descr="Needle">
                  <a:extLst>
                    <a:ext uri="{FF2B5EF4-FFF2-40B4-BE49-F238E27FC236}">
                      <a16:creationId xmlns:a16="http://schemas.microsoft.com/office/drawing/2014/main" id="{2C5C1E16-7121-9740-50F4-7D0696DB3B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18393" y="286011"/>
                  <a:ext cx="226846" cy="194835"/>
                </a:xfrm>
                <a:prstGeom prst="rect">
                  <a:avLst/>
                </a:prstGeom>
              </p:spPr>
            </p:pic>
          </p:grp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8CF0370C-D387-3B0E-9D50-1A5E36025906}"/>
                  </a:ext>
                </a:extLst>
              </p:cNvPr>
              <p:cNvGrpSpPr/>
              <p:nvPr/>
            </p:nvGrpSpPr>
            <p:grpSpPr>
              <a:xfrm>
                <a:off x="2912249" y="345702"/>
                <a:ext cx="1302093" cy="609705"/>
                <a:chOff x="807554" y="492538"/>
                <a:chExt cx="1302093" cy="609705"/>
              </a:xfrm>
            </p:grpSpPr>
            <p:pic>
              <p:nvPicPr>
                <p:cNvPr id="50" name="Graphic 49" descr="Needle">
                  <a:extLst>
                    <a:ext uri="{FF2B5EF4-FFF2-40B4-BE49-F238E27FC236}">
                      <a16:creationId xmlns:a16="http://schemas.microsoft.com/office/drawing/2014/main" id="{44515118-4331-CBCB-53E4-E6E51C8DAD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82801" y="547844"/>
                  <a:ext cx="226846" cy="194835"/>
                </a:xfrm>
                <a:prstGeom prst="rect">
                  <a:avLst/>
                </a:prstGeom>
              </p:spPr>
            </p:pic>
            <p:pic>
              <p:nvPicPr>
                <p:cNvPr id="51" name="Picture 10" descr="Laboratory mouse - Wikipedia">
                  <a:extLst>
                    <a:ext uri="{FF2B5EF4-FFF2-40B4-BE49-F238E27FC236}">
                      <a16:creationId xmlns:a16="http://schemas.microsoft.com/office/drawing/2014/main" id="{9713A456-B807-3958-6BDB-CB9798096F8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807554" y="492538"/>
                  <a:ext cx="1104585" cy="6097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45CBC6F0-56A6-E4A0-6FFB-32C9477E0FC4}"/>
                  </a:ext>
                </a:extLst>
              </p:cNvPr>
              <p:cNvGrpSpPr/>
              <p:nvPr/>
            </p:nvGrpSpPr>
            <p:grpSpPr>
              <a:xfrm>
                <a:off x="5092081" y="381231"/>
                <a:ext cx="1302093" cy="609705"/>
                <a:chOff x="807554" y="492538"/>
                <a:chExt cx="1302093" cy="609705"/>
              </a:xfrm>
            </p:grpSpPr>
            <p:pic>
              <p:nvPicPr>
                <p:cNvPr id="53" name="Graphic 52" descr="Needle">
                  <a:extLst>
                    <a:ext uri="{FF2B5EF4-FFF2-40B4-BE49-F238E27FC236}">
                      <a16:creationId xmlns:a16="http://schemas.microsoft.com/office/drawing/2014/main" id="{7634A27C-57AA-928E-D82D-CBC8EE6CC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82801" y="547844"/>
                  <a:ext cx="226846" cy="194835"/>
                </a:xfrm>
                <a:prstGeom prst="rect">
                  <a:avLst/>
                </a:prstGeom>
              </p:spPr>
            </p:pic>
            <p:pic>
              <p:nvPicPr>
                <p:cNvPr id="54" name="Picture 10" descr="Laboratory mouse - Wikipedia">
                  <a:extLst>
                    <a:ext uri="{FF2B5EF4-FFF2-40B4-BE49-F238E27FC236}">
                      <a16:creationId xmlns:a16="http://schemas.microsoft.com/office/drawing/2014/main" id="{F10CFC06-A9F8-B6B5-A0D7-08A1345823F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807554" y="492538"/>
                  <a:ext cx="1104585" cy="6097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</p:grpSp>
        <p:graphicFrame>
          <p:nvGraphicFramePr>
            <p:cNvPr id="61" name="Object 60">
              <a:extLst>
                <a:ext uri="{FF2B5EF4-FFF2-40B4-BE49-F238E27FC236}">
                  <a16:creationId xmlns:a16="http://schemas.microsoft.com/office/drawing/2014/main" id="{B902D8BE-3CB6-829B-A3B8-DB229F049B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53638630"/>
                </p:ext>
              </p:extLst>
            </p:nvPr>
          </p:nvGraphicFramePr>
          <p:xfrm>
            <a:off x="3758180" y="1227183"/>
            <a:ext cx="3579865" cy="2781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4186578" imgH="3251226" progId="Prism9.Document">
                    <p:embed/>
                  </p:oleObj>
                </mc:Choice>
                <mc:Fallback>
                  <p:oleObj name="Prism 9" r:id="rId10" imgW="4186578" imgH="3251226" progId="Prism9.Document">
                    <p:embed/>
                    <p:pic>
                      <p:nvPicPr>
                        <p:cNvPr id="61" name="Object 60">
                          <a:extLst>
                            <a:ext uri="{FF2B5EF4-FFF2-40B4-BE49-F238E27FC236}">
                              <a16:creationId xmlns:a16="http://schemas.microsoft.com/office/drawing/2014/main" id="{B902D8BE-3CB6-829B-A3B8-DB229F049B8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758180" y="1227183"/>
                          <a:ext cx="3579865" cy="2781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9" name="Object 58">
              <a:extLst>
                <a:ext uri="{FF2B5EF4-FFF2-40B4-BE49-F238E27FC236}">
                  <a16:creationId xmlns:a16="http://schemas.microsoft.com/office/drawing/2014/main" id="{FA8B64A2-2D2E-2077-9FE7-96BCCCD2532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10665216"/>
                </p:ext>
              </p:extLst>
            </p:nvPr>
          </p:nvGraphicFramePr>
          <p:xfrm>
            <a:off x="158252" y="1271815"/>
            <a:ext cx="3517479" cy="27819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4183336" imgH="3312074" progId="Prism9.Document">
                    <p:embed/>
                  </p:oleObj>
                </mc:Choice>
                <mc:Fallback>
                  <p:oleObj name="Prism 9" r:id="rId12" imgW="4183336" imgH="3312074" progId="Prism9.Document">
                    <p:embed/>
                    <p:pic>
                      <p:nvPicPr>
                        <p:cNvPr id="59" name="Object 58">
                          <a:extLst>
                            <a:ext uri="{FF2B5EF4-FFF2-40B4-BE49-F238E27FC236}">
                              <a16:creationId xmlns:a16="http://schemas.microsoft.com/office/drawing/2014/main" id="{FA8B64A2-2D2E-2077-9FE7-96BCCCD2532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58252" y="1271815"/>
                          <a:ext cx="3517479" cy="27819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AB84E30-3152-53BE-E3C6-D5CCD7C55C4C}"/>
                </a:ext>
              </a:extLst>
            </p:cNvPr>
            <p:cNvSpPr txBox="1"/>
            <p:nvPr/>
          </p:nvSpPr>
          <p:spPr>
            <a:xfrm>
              <a:off x="27630" y="1260816"/>
              <a:ext cx="5238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83BE155-5A6D-936A-A06C-1C823CD966D4}"/>
                </a:ext>
              </a:extLst>
            </p:cNvPr>
            <p:cNvSpPr txBox="1"/>
            <p:nvPr/>
          </p:nvSpPr>
          <p:spPr>
            <a:xfrm>
              <a:off x="3645763" y="1260816"/>
              <a:ext cx="5238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4B439D9-CB9B-AF92-24A4-4CE548265E02}"/>
                </a:ext>
              </a:extLst>
            </p:cNvPr>
            <p:cNvSpPr txBox="1"/>
            <p:nvPr/>
          </p:nvSpPr>
          <p:spPr>
            <a:xfrm>
              <a:off x="7337414" y="1260816"/>
              <a:ext cx="5238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D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D120B8DF-B192-17B8-598F-DE97E75C2596}"/>
                </a:ext>
              </a:extLst>
            </p:cNvPr>
            <p:cNvSpPr/>
            <p:nvPr/>
          </p:nvSpPr>
          <p:spPr>
            <a:xfrm>
              <a:off x="551459" y="3534082"/>
              <a:ext cx="1076417" cy="4175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E1557DDD-86AF-8DEA-5016-97C7A6C64FF4}"/>
                </a:ext>
              </a:extLst>
            </p:cNvPr>
            <p:cNvSpPr/>
            <p:nvPr/>
          </p:nvSpPr>
          <p:spPr>
            <a:xfrm>
              <a:off x="4117737" y="3494191"/>
              <a:ext cx="1163843" cy="4175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C55953FD-4F2E-7AB6-686E-4A6E378B1277}"/>
                </a:ext>
              </a:extLst>
            </p:cNvPr>
            <p:cNvSpPr/>
            <p:nvPr/>
          </p:nvSpPr>
          <p:spPr>
            <a:xfrm>
              <a:off x="7861243" y="3494191"/>
              <a:ext cx="1163843" cy="4175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32101ED-F8AC-67F7-A33A-9AC6A3F4D909}"/>
                </a:ext>
              </a:extLst>
            </p:cNvPr>
            <p:cNvSpPr txBox="1"/>
            <p:nvPr/>
          </p:nvSpPr>
          <p:spPr>
            <a:xfrm>
              <a:off x="89383" y="3965260"/>
              <a:ext cx="5238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E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AEAA80EF-A206-544E-6B45-A4A88421FE93}"/>
                </a:ext>
              </a:extLst>
            </p:cNvPr>
            <p:cNvSpPr/>
            <p:nvPr/>
          </p:nvSpPr>
          <p:spPr>
            <a:xfrm>
              <a:off x="565994" y="6450424"/>
              <a:ext cx="1222582" cy="58596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2AB569E-EBDA-94F1-D9B6-A6FBBFF27B46}"/>
                </a:ext>
              </a:extLst>
            </p:cNvPr>
            <p:cNvSpPr txBox="1"/>
            <p:nvPr/>
          </p:nvSpPr>
          <p:spPr>
            <a:xfrm>
              <a:off x="3214975" y="2776246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BE16163-523E-054E-0DA1-B2896AF8C2C4}"/>
                </a:ext>
              </a:extLst>
            </p:cNvPr>
            <p:cNvSpPr txBox="1"/>
            <p:nvPr/>
          </p:nvSpPr>
          <p:spPr>
            <a:xfrm>
              <a:off x="6881378" y="2821966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26C0B95-C580-47AB-7F17-ADB3783E34BE}"/>
                </a:ext>
              </a:extLst>
            </p:cNvPr>
            <p:cNvSpPr txBox="1"/>
            <p:nvPr/>
          </p:nvSpPr>
          <p:spPr>
            <a:xfrm>
              <a:off x="6131800" y="759494"/>
              <a:ext cx="120561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48 hrs</a:t>
              </a:r>
            </a:p>
            <a:p>
              <a:pPr algn="ctr"/>
              <a:r>
                <a:rPr lang="en-CA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4, 8 , 12, 24 </a:t>
              </a:r>
              <a:r>
                <a:rPr lang="en-CA" sz="11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wks</a:t>
              </a:r>
              <a:endParaRPr lang="en-CA" sz="11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318E10B-5ED6-069C-88FC-55C25BDA0EB7}"/>
              </a:ext>
            </a:extLst>
          </p:cNvPr>
          <p:cNvSpPr txBox="1"/>
          <p:nvPr/>
        </p:nvSpPr>
        <p:spPr>
          <a:xfrm>
            <a:off x="-20636" y="7144835"/>
            <a:ext cx="1223129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5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omparison of streptomycin pre-treatment and no pre-treatment in BALB/c mice</a:t>
            </a:r>
          </a:p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o determine whether streptomycin pre-treatment would also increase infection in BALB/c mice, infection outcomes were compared between BALB/c mice given streptomycin pre-treatment or no pre-treatment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BALB/c mice were given 20mg streptomycin or no pre-treatment followed by 2 consecutive doses of 10</a:t>
            </a: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9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FU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each 24-hours apart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-D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CFUs of the large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small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and MLNs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were compared between mice groups 48-hours, 4-, 8-, 12-, and 24-weeks post-infection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E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Fecal pellets were collected and processed from uninfected BALB/c mice and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P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-infected BALB/c mice with or without streptomycin pre-treatment. The levels of lipocalin-2 found in the feces of each group were evaluated by ELISA (*p&lt;0.05, **p&lt;0.01). </a:t>
            </a:r>
          </a:p>
        </p:txBody>
      </p:sp>
    </p:spTree>
    <p:extLst>
      <p:ext uri="{BB962C8B-B14F-4D97-AF65-F5344CB8AC3E}">
        <p14:creationId xmlns:p14="http://schemas.microsoft.com/office/powerpoint/2010/main" val="21582188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ADCFF6B3-9885-2D0E-E28D-4B5D675AAA9C}"/>
              </a:ext>
            </a:extLst>
          </p:cNvPr>
          <p:cNvGrpSpPr/>
          <p:nvPr/>
        </p:nvGrpSpPr>
        <p:grpSpPr>
          <a:xfrm>
            <a:off x="65218" y="25728"/>
            <a:ext cx="5864077" cy="4427214"/>
            <a:chOff x="65218" y="25728"/>
            <a:chExt cx="5864077" cy="442721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4BB11FA-C689-F115-5DDA-4FE069D2F24B}"/>
                </a:ext>
              </a:extLst>
            </p:cNvPr>
            <p:cNvSpPr txBox="1"/>
            <p:nvPr/>
          </p:nvSpPr>
          <p:spPr>
            <a:xfrm>
              <a:off x="65218" y="2572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EDDFDA0-4B97-534C-5AB6-CBDE2A30A7A3}"/>
                </a:ext>
              </a:extLst>
            </p:cNvPr>
            <p:cNvSpPr txBox="1"/>
            <p:nvPr/>
          </p:nvSpPr>
          <p:spPr>
            <a:xfrm>
              <a:off x="65218" y="2188250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D55A7704-F198-B73B-EEB6-DAA02E41E68F}"/>
                </a:ext>
              </a:extLst>
            </p:cNvPr>
            <p:cNvGrpSpPr/>
            <p:nvPr/>
          </p:nvGrpSpPr>
          <p:grpSpPr>
            <a:xfrm>
              <a:off x="359227" y="517787"/>
              <a:ext cx="5570068" cy="1638539"/>
              <a:chOff x="411480" y="618470"/>
              <a:chExt cx="5570068" cy="1638539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28724726-A093-5D39-8A98-D9996E0F4EFB}"/>
                  </a:ext>
                </a:extLst>
              </p:cNvPr>
              <p:cNvGrpSpPr/>
              <p:nvPr/>
            </p:nvGrpSpPr>
            <p:grpSpPr>
              <a:xfrm>
                <a:off x="411480" y="618470"/>
                <a:ext cx="5570068" cy="1638539"/>
                <a:chOff x="6218585" y="2527961"/>
                <a:chExt cx="5570068" cy="1638539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A3F703E2-D033-8E55-636F-CBA2AD5E323B}"/>
                    </a:ext>
                  </a:extLst>
                </p:cNvPr>
                <p:cNvSpPr txBox="1"/>
                <p:nvPr/>
              </p:nvSpPr>
              <p:spPr>
                <a:xfrm>
                  <a:off x="6612710" y="3758096"/>
                  <a:ext cx="148317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WT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AH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9238E2FF-D2DD-28D7-AB78-3147127CC08E}"/>
                    </a:ext>
                  </a:extLst>
                </p:cNvPr>
                <p:cNvSpPr txBox="1"/>
                <p:nvPr/>
              </p:nvSpPr>
              <p:spPr>
                <a:xfrm>
                  <a:off x="6218585" y="2584071"/>
                  <a:ext cx="26142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Strep-R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AH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97F556D4-1E22-2047-C364-1335F86B73F0}"/>
                    </a:ext>
                  </a:extLst>
                </p:cNvPr>
                <p:cNvGrpSpPr/>
                <p:nvPr/>
              </p:nvGrpSpPr>
              <p:grpSpPr>
                <a:xfrm>
                  <a:off x="7377545" y="2527961"/>
                  <a:ext cx="4411108" cy="1638539"/>
                  <a:chOff x="7091747" y="2359331"/>
                  <a:chExt cx="4696906" cy="1807169"/>
                </a:xfrm>
              </p:grpSpPr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8217BDB2-1709-18F9-CF3B-FF0B2A9E1A4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7091747" y="2359331"/>
                    <a:ext cx="4696905" cy="1273493"/>
                  </a:xfrm>
                  <a:prstGeom prst="rect">
                    <a:avLst/>
                  </a:prstGeom>
                </p:spPr>
              </p:pic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D9D50BEB-0653-06B7-D83C-F741FFF86ED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7091747" y="3623038"/>
                    <a:ext cx="4696906" cy="543462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D84047B3-9980-8488-6643-1E2DC40BFD8A}"/>
                  </a:ext>
                </a:extLst>
              </p:cNvPr>
              <p:cNvSpPr/>
              <p:nvPr/>
            </p:nvSpPr>
            <p:spPr>
              <a:xfrm>
                <a:off x="3686671" y="1543048"/>
                <a:ext cx="259080" cy="137160"/>
              </a:xfrm>
              <a:prstGeom prst="rect">
                <a:avLst/>
              </a:prstGeom>
              <a:noFill/>
              <a:ln w="38100">
                <a:solidFill>
                  <a:srgbClr val="3BE93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62F9AF4-8A1B-C61A-73B0-27BC14380694}"/>
                </a:ext>
              </a:extLst>
            </p:cNvPr>
            <p:cNvGrpSpPr/>
            <p:nvPr/>
          </p:nvGrpSpPr>
          <p:grpSpPr>
            <a:xfrm>
              <a:off x="212645" y="2666979"/>
              <a:ext cx="5698000" cy="1785963"/>
              <a:chOff x="274320" y="3328597"/>
              <a:chExt cx="5698000" cy="1785963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A5C9285-567C-2AEB-7C91-6891C44E2070}"/>
                  </a:ext>
                </a:extLst>
              </p:cNvPr>
              <p:cNvGrpSpPr/>
              <p:nvPr/>
            </p:nvGrpSpPr>
            <p:grpSpPr>
              <a:xfrm>
                <a:off x="274320" y="3328597"/>
                <a:ext cx="5698000" cy="1785963"/>
                <a:chOff x="6133224" y="4064119"/>
                <a:chExt cx="5698000" cy="1785963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88E203F5-77A6-8E17-ACBB-544578EBD55B}"/>
                    </a:ext>
                  </a:extLst>
                </p:cNvPr>
                <p:cNvGrpSpPr/>
                <p:nvPr/>
              </p:nvGrpSpPr>
              <p:grpSpPr>
                <a:xfrm>
                  <a:off x="7444807" y="4064119"/>
                  <a:ext cx="4386417" cy="1785963"/>
                  <a:chOff x="7372070" y="4064119"/>
                  <a:chExt cx="4386417" cy="1785963"/>
                </a:xfrm>
              </p:grpSpPr>
              <p:pic>
                <p:nvPicPr>
                  <p:cNvPr id="14" name="Picture 13">
                    <a:extLst>
                      <a:ext uri="{FF2B5EF4-FFF2-40B4-BE49-F238E27FC236}">
                        <a16:creationId xmlns:a16="http://schemas.microsoft.com/office/drawing/2014/main" id="{2A0CF333-FA39-273B-F59C-B0020B1901C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7372070" y="4064119"/>
                    <a:ext cx="4362862" cy="1256025"/>
                  </a:xfrm>
                  <a:prstGeom prst="rect">
                    <a:avLst/>
                  </a:prstGeom>
                </p:spPr>
              </p:pic>
              <p:pic>
                <p:nvPicPr>
                  <p:cNvPr id="15" name="Picture 14">
                    <a:extLst>
                      <a:ext uri="{FF2B5EF4-FFF2-40B4-BE49-F238E27FC236}">
                        <a16:creationId xmlns:a16="http://schemas.microsoft.com/office/drawing/2014/main" id="{BE00CD91-18AC-8C53-EA1D-AB7C7932014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7372070" y="5320144"/>
                    <a:ext cx="4386417" cy="529938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BD7FD149-461A-8647-E6B9-A517BBC168AA}"/>
                    </a:ext>
                  </a:extLst>
                </p:cNvPr>
                <p:cNvSpPr txBox="1"/>
                <p:nvPr/>
              </p:nvSpPr>
              <p:spPr>
                <a:xfrm>
                  <a:off x="6426199" y="5415837"/>
                  <a:ext cx="150280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WT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. </a:t>
                  </a:r>
                  <a:r>
                    <a:rPr lang="en-CA" sz="1400" i="1" dirty="0" err="1">
                      <a:latin typeface="Calibri" panose="020F0502020204030204" pitchFamily="34" charset="0"/>
                      <a:cs typeface="Calibri" panose="020F0502020204030204" pitchFamily="34" charset="0"/>
                    </a:rPr>
                    <a:t>bovis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657ADBDA-7445-2495-B111-E50A9931F571}"/>
                    </a:ext>
                  </a:extLst>
                </p:cNvPr>
                <p:cNvSpPr txBox="1"/>
                <p:nvPr/>
              </p:nvSpPr>
              <p:spPr>
                <a:xfrm>
                  <a:off x="6133224" y="4153964"/>
                  <a:ext cx="226660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Strep-R </a:t>
                  </a:r>
                  <a:r>
                    <a:rPr lang="en-CA" sz="1400" i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M. </a:t>
                  </a:r>
                  <a:r>
                    <a:rPr lang="en-CA" sz="1400" i="1" dirty="0" err="1">
                      <a:latin typeface="Calibri" panose="020F0502020204030204" pitchFamily="34" charset="0"/>
                      <a:cs typeface="Calibri" panose="020F0502020204030204" pitchFamily="34" charset="0"/>
                    </a:rPr>
                    <a:t>bovis</a:t>
                  </a:r>
                  <a:endParaRPr lang="en-CA" sz="14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8146180D-7E85-C9A6-8B2B-C736B897E383}"/>
                  </a:ext>
                </a:extLst>
              </p:cNvPr>
              <p:cNvSpPr/>
              <p:nvPr/>
            </p:nvSpPr>
            <p:spPr>
              <a:xfrm>
                <a:off x="3683144" y="4351797"/>
                <a:ext cx="259080" cy="137160"/>
              </a:xfrm>
              <a:prstGeom prst="rect">
                <a:avLst/>
              </a:prstGeom>
              <a:noFill/>
              <a:ln w="38100">
                <a:solidFill>
                  <a:srgbClr val="3BE93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D84DF1C9-D324-AFC2-7EC2-B419EE55CA10}"/>
              </a:ext>
            </a:extLst>
          </p:cNvPr>
          <p:cNvSpPr txBox="1"/>
          <p:nvPr/>
        </p:nvSpPr>
        <p:spPr>
          <a:xfrm>
            <a:off x="65218" y="4761541"/>
            <a:ext cx="121920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6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Generation of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Oligo-mediated recombineering was employed to generate a K43R mutation in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sequence of the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gene of WT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was generated by Sanger sequencing. Amino acids 42-44 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were visualized on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Geneiou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Prime and the point mutation in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AH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is indicated by a green box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sequence of the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gene of WT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nd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was generated by Sanger sequencing. Amino acids 42-44 of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rpsL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were visualized on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Geneiou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Prime and the point mutation in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</a:t>
            </a:r>
            <a:r>
              <a:rPr lang="en-US" sz="14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bovis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is highlighted by a green box.</a:t>
            </a:r>
          </a:p>
        </p:txBody>
      </p:sp>
    </p:spTree>
    <p:extLst>
      <p:ext uri="{BB962C8B-B14F-4D97-AF65-F5344CB8AC3E}">
        <p14:creationId xmlns:p14="http://schemas.microsoft.com/office/powerpoint/2010/main" val="41636198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AB0BFB54-23A1-F0C9-76B6-402372C643F6}"/>
              </a:ext>
            </a:extLst>
          </p:cNvPr>
          <p:cNvGrpSpPr/>
          <p:nvPr/>
        </p:nvGrpSpPr>
        <p:grpSpPr>
          <a:xfrm>
            <a:off x="0" y="109428"/>
            <a:ext cx="9982603" cy="6856162"/>
            <a:chOff x="0" y="109428"/>
            <a:chExt cx="9982603" cy="6856162"/>
          </a:xfrm>
        </p:grpSpPr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60EB0BB7-B3DA-9533-7233-21B29DABF86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655881"/>
                </p:ext>
              </p:extLst>
            </p:nvPr>
          </p:nvGraphicFramePr>
          <p:xfrm>
            <a:off x="2380902" y="1391098"/>
            <a:ext cx="2450054" cy="23677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837149" imgH="2742119" progId="Prism9.Document">
                    <p:embed/>
                  </p:oleObj>
                </mc:Choice>
                <mc:Fallback>
                  <p:oleObj name="Prism 9" r:id="rId3" imgW="2837149" imgH="2742119" progId="Prism9.Document">
                    <p:embed/>
                    <p:pic>
                      <p:nvPicPr>
                        <p:cNvPr id="39" name="Object 38">
                          <a:extLst>
                            <a:ext uri="{FF2B5EF4-FFF2-40B4-BE49-F238E27FC236}">
                              <a16:creationId xmlns:a16="http://schemas.microsoft.com/office/drawing/2014/main" id="{60EB0BB7-B3DA-9533-7233-21B29DABF86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380902" y="1391098"/>
                          <a:ext cx="2450054" cy="23677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CFBCA48-FAD7-7157-0939-8E9D9CC35BEA}"/>
                </a:ext>
              </a:extLst>
            </p:cNvPr>
            <p:cNvSpPr txBox="1"/>
            <p:nvPr/>
          </p:nvSpPr>
          <p:spPr>
            <a:xfrm>
              <a:off x="0" y="10942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B8ECE6C-093D-5B72-1EB5-BB98E2D659DE}"/>
                </a:ext>
              </a:extLst>
            </p:cNvPr>
            <p:cNvGrpSpPr/>
            <p:nvPr/>
          </p:nvGrpSpPr>
          <p:grpSpPr>
            <a:xfrm>
              <a:off x="484320" y="189883"/>
              <a:ext cx="7924099" cy="1131896"/>
              <a:chOff x="512893" y="1924635"/>
              <a:chExt cx="7924099" cy="113189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E05FD73-0CF7-6A1A-988E-D73FD7221BF4}"/>
                  </a:ext>
                </a:extLst>
              </p:cNvPr>
              <p:cNvSpPr txBox="1"/>
              <p:nvPr/>
            </p:nvSpPr>
            <p:spPr>
              <a:xfrm>
                <a:off x="512893" y="1940133"/>
                <a:ext cx="18838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0mg streptomycin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78452D1-057C-9C9E-A2BE-EF51F2E8BA64}"/>
                  </a:ext>
                </a:extLst>
              </p:cNvPr>
              <p:cNvSpPr txBox="1"/>
              <p:nvPr/>
            </p:nvSpPr>
            <p:spPr>
              <a:xfrm>
                <a:off x="2203588" y="2498086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03F6DC2-22E3-DF87-D06E-C7F5E9D892CF}"/>
                  </a:ext>
                </a:extLst>
              </p:cNvPr>
              <p:cNvSpPr txBox="1"/>
              <p:nvPr/>
            </p:nvSpPr>
            <p:spPr>
              <a:xfrm>
                <a:off x="2693917" y="1924635"/>
                <a:ext cx="20582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. orygis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8CD9E50-9383-28EC-DC27-A4953969808B}"/>
                  </a:ext>
                </a:extLst>
              </p:cNvPr>
              <p:cNvSpPr txBox="1"/>
              <p:nvPr/>
            </p:nvSpPr>
            <p:spPr>
              <a:xfrm>
                <a:off x="7231380" y="2247910"/>
                <a:ext cx="120561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acrifice</a:t>
                </a:r>
              </a:p>
              <a:p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Collect organs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59FEB98-C14E-D79F-932D-6BC0A3B66065}"/>
                  </a:ext>
                </a:extLst>
              </p:cNvPr>
              <p:cNvSpPr txBox="1"/>
              <p:nvPr/>
            </p:nvSpPr>
            <p:spPr>
              <a:xfrm>
                <a:off x="935331" y="2794921"/>
                <a:ext cx="8405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C57BL/6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26E0EC7A-C10F-C521-26DE-E49045F6BED8}"/>
                  </a:ext>
                </a:extLst>
              </p:cNvPr>
              <p:cNvGrpSpPr/>
              <p:nvPr/>
            </p:nvGrpSpPr>
            <p:grpSpPr>
              <a:xfrm>
                <a:off x="2863550" y="2211140"/>
                <a:ext cx="1332654" cy="660423"/>
                <a:chOff x="3650950" y="562542"/>
                <a:chExt cx="1332654" cy="660423"/>
              </a:xfrm>
            </p:grpSpPr>
            <p:pic>
              <p:nvPicPr>
                <p:cNvPr id="24" name="Picture 6" descr="Image result for mouse clipart science">
                  <a:extLst>
                    <a:ext uri="{FF2B5EF4-FFF2-40B4-BE49-F238E27FC236}">
                      <a16:creationId xmlns:a16="http://schemas.microsoft.com/office/drawing/2014/main" id="{24CF0185-96E4-02F3-FE29-C8EA72EEA4A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50950" y="562542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" name="Graphic 24" descr="Needle">
                  <a:extLst>
                    <a:ext uri="{FF2B5EF4-FFF2-40B4-BE49-F238E27FC236}">
                      <a16:creationId xmlns:a16="http://schemas.microsoft.com/office/drawing/2014/main" id="{06AAD0CB-CA1C-E111-264B-78AFC4A802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7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6758" y="623271"/>
                  <a:ext cx="226846" cy="194835"/>
                </a:xfrm>
                <a:prstGeom prst="rect">
                  <a:avLst/>
                </a:prstGeom>
              </p:spPr>
            </p:pic>
          </p:grp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69DF870D-C0D6-4065-70CE-51B22D960E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27713" y="2509520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BB15401-9D05-5AD3-DE7A-82851DCB5ED1}"/>
                  </a:ext>
                </a:extLst>
              </p:cNvPr>
              <p:cNvSpPr txBox="1"/>
              <p:nvPr/>
            </p:nvSpPr>
            <p:spPr>
              <a:xfrm>
                <a:off x="6163577" y="2498086"/>
                <a:ext cx="9255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4, 24 </a:t>
                </a:r>
                <a:r>
                  <a:rPr lang="en-CA" sz="110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wks</a:t>
                </a:r>
                <a:endParaRPr lang="en-CA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1DCF3D16-976B-3E0D-7F04-06508E55C1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1783" y="2509520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147E2956-2935-1535-0272-E2B77066C0C5}"/>
                  </a:ext>
                </a:extLst>
              </p:cNvPr>
              <p:cNvGrpSpPr/>
              <p:nvPr/>
            </p:nvGrpSpPr>
            <p:grpSpPr>
              <a:xfrm>
                <a:off x="805568" y="2211140"/>
                <a:ext cx="1332654" cy="660423"/>
                <a:chOff x="1592968" y="528898"/>
                <a:chExt cx="1332654" cy="660423"/>
              </a:xfrm>
            </p:grpSpPr>
            <p:pic>
              <p:nvPicPr>
                <p:cNvPr id="22" name="Picture 6" descr="Image result for mouse clipart science">
                  <a:extLst>
                    <a:ext uri="{FF2B5EF4-FFF2-40B4-BE49-F238E27FC236}">
                      <a16:creationId xmlns:a16="http://schemas.microsoft.com/office/drawing/2014/main" id="{87FC7C1B-19EF-F197-93E7-87C411391C5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592968" y="528898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" name="Graphic 22" descr="Needle">
                  <a:extLst>
                    <a:ext uri="{FF2B5EF4-FFF2-40B4-BE49-F238E27FC236}">
                      <a16:creationId xmlns:a16="http://schemas.microsoft.com/office/drawing/2014/main" id="{F6E6BE23-B03B-5AF1-9230-BBAFF405B2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7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8776" y="589627"/>
                  <a:ext cx="226846" cy="194835"/>
                </a:xfrm>
                <a:prstGeom prst="rect">
                  <a:avLst/>
                </a:prstGeom>
              </p:spPr>
            </p:pic>
          </p:grp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A0ECB27-4EDB-CA40-2DC7-D52E04F40907}"/>
                  </a:ext>
                </a:extLst>
              </p:cNvPr>
              <p:cNvSpPr txBox="1"/>
              <p:nvPr/>
            </p:nvSpPr>
            <p:spPr>
              <a:xfrm>
                <a:off x="4261835" y="2496415"/>
                <a:ext cx="70546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24 hrs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F97EC58-169B-9053-7C73-6DB28369A2C9}"/>
                  </a:ext>
                </a:extLst>
              </p:cNvPr>
              <p:cNvSpPr txBox="1"/>
              <p:nvPr/>
            </p:nvSpPr>
            <p:spPr>
              <a:xfrm>
                <a:off x="4752164" y="1938462"/>
                <a:ext cx="20582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400" baseline="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9</a:t>
                </a:r>
                <a:r>
                  <a:rPr lang="en-CA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CFU strep-R</a:t>
                </a:r>
                <a:r>
                  <a:rPr lang="en-CA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. orygis</a:t>
                </a:r>
                <a:endParaRPr lang="en-CA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879668E1-BBED-EAD4-B235-F846964425B3}"/>
                  </a:ext>
                </a:extLst>
              </p:cNvPr>
              <p:cNvGrpSpPr/>
              <p:nvPr/>
            </p:nvGrpSpPr>
            <p:grpSpPr>
              <a:xfrm>
                <a:off x="4921797" y="2209469"/>
                <a:ext cx="1332654" cy="660423"/>
                <a:chOff x="3650950" y="562542"/>
                <a:chExt cx="1332654" cy="660423"/>
              </a:xfrm>
            </p:grpSpPr>
            <p:pic>
              <p:nvPicPr>
                <p:cNvPr id="20" name="Picture 6" descr="Image result for mouse clipart science">
                  <a:extLst>
                    <a:ext uri="{FF2B5EF4-FFF2-40B4-BE49-F238E27FC236}">
                      <a16:creationId xmlns:a16="http://schemas.microsoft.com/office/drawing/2014/main" id="{DC679FE2-AAF4-54EA-D058-901A936CA48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clrChange>
                    <a:clrFrom>
                      <a:srgbClr val="EDEDED"/>
                    </a:clrFrom>
                    <a:clrTo>
                      <a:srgbClr val="EDEDED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50950" y="562542"/>
                  <a:ext cx="1163778" cy="66042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1" name="Graphic 20" descr="Needle">
                  <a:extLst>
                    <a:ext uri="{FF2B5EF4-FFF2-40B4-BE49-F238E27FC236}">
                      <a16:creationId xmlns:a16="http://schemas.microsoft.com/office/drawing/2014/main" id="{425C733B-F1F5-FAED-F6A7-A844846953A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/>
                    </a:ext>
                    <a:ext uri="{96DAC541-7B7A-43D3-8B79-37D633B846F1}">
                      <asvg:svgBlip xmlns:asvg="http://schemas.microsoft.com/office/drawing/2016/SVG/main" r:embed="rId7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6758" y="623271"/>
                  <a:ext cx="226846" cy="194835"/>
                </a:xfrm>
                <a:prstGeom prst="rect">
                  <a:avLst/>
                </a:prstGeom>
              </p:spPr>
            </p:pic>
          </p:grp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3DE44E56-8D60-D6ED-3D94-6ACA3CE254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20030" y="2507849"/>
                <a:ext cx="903667" cy="0"/>
              </a:xfrm>
              <a:prstGeom prst="straightConnector1">
                <a:avLst/>
              </a:prstGeom>
              <a:ln w="57150">
                <a:solidFill>
                  <a:schemeClr val="bg2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83D31C6-9BE6-BA05-08AF-B17CB6FE1FD5}"/>
                </a:ext>
              </a:extLst>
            </p:cNvPr>
            <p:cNvSpPr txBox="1"/>
            <p:nvPr/>
          </p:nvSpPr>
          <p:spPr>
            <a:xfrm>
              <a:off x="35723" y="120877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A508A80-9A06-DA56-F21D-30F39D48AA1F}"/>
                </a:ext>
              </a:extLst>
            </p:cNvPr>
            <p:cNvSpPr txBox="1"/>
            <p:nvPr/>
          </p:nvSpPr>
          <p:spPr>
            <a:xfrm>
              <a:off x="2355147" y="120877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DD91437-D38A-E1CA-B14F-A45F769CED0C}"/>
                </a:ext>
              </a:extLst>
            </p:cNvPr>
            <p:cNvSpPr txBox="1"/>
            <p:nvPr/>
          </p:nvSpPr>
          <p:spPr>
            <a:xfrm>
              <a:off x="4723589" y="120877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D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A085A63-EB50-D451-5E5E-489F0F9F3D76}"/>
                </a:ext>
              </a:extLst>
            </p:cNvPr>
            <p:cNvSpPr txBox="1"/>
            <p:nvPr/>
          </p:nvSpPr>
          <p:spPr>
            <a:xfrm>
              <a:off x="7092031" y="1208778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E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D066372-A289-5BCD-66A5-1AED843080E7}"/>
                </a:ext>
              </a:extLst>
            </p:cNvPr>
            <p:cNvSpPr txBox="1"/>
            <p:nvPr/>
          </p:nvSpPr>
          <p:spPr>
            <a:xfrm>
              <a:off x="2074647" y="2960982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E8AC3AC-07AD-57E1-6D01-26C87206564B}"/>
                </a:ext>
              </a:extLst>
            </p:cNvPr>
            <p:cNvSpPr txBox="1"/>
            <p:nvPr/>
          </p:nvSpPr>
          <p:spPr>
            <a:xfrm>
              <a:off x="4387548" y="3069369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37858DD-1945-E3AC-C0AA-FF7336B940C5}"/>
                </a:ext>
              </a:extLst>
            </p:cNvPr>
            <p:cNvSpPr txBox="1"/>
            <p:nvPr/>
          </p:nvSpPr>
          <p:spPr>
            <a:xfrm>
              <a:off x="9282022" y="3166721"/>
              <a:ext cx="7005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OD</a:t>
              </a:r>
            </a:p>
          </p:txBody>
        </p:sp>
        <p:graphicFrame>
          <p:nvGraphicFramePr>
            <p:cNvPr id="38" name="Object 37">
              <a:extLst>
                <a:ext uri="{FF2B5EF4-FFF2-40B4-BE49-F238E27FC236}">
                  <a16:creationId xmlns:a16="http://schemas.microsoft.com/office/drawing/2014/main" id="{F82DF8A0-A1A7-77DF-0C5C-9F82C2BF3F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10091895"/>
                </p:ext>
              </p:extLst>
            </p:nvPr>
          </p:nvGraphicFramePr>
          <p:xfrm>
            <a:off x="74290" y="1350899"/>
            <a:ext cx="2444146" cy="23620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2837149" imgH="2742119" progId="Prism9.Document">
                    <p:embed/>
                  </p:oleObj>
                </mc:Choice>
                <mc:Fallback>
                  <p:oleObj name="Prism 9" r:id="rId8" imgW="2837149" imgH="2742119" progId="Prism9.Document">
                    <p:embed/>
                    <p:pic>
                      <p:nvPicPr>
                        <p:cNvPr id="38" name="Object 37">
                          <a:extLst>
                            <a:ext uri="{FF2B5EF4-FFF2-40B4-BE49-F238E27FC236}">
                              <a16:creationId xmlns:a16="http://schemas.microsoft.com/office/drawing/2014/main" id="{F82DF8A0-A1A7-77DF-0C5C-9F82C2BF3FE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4290" y="1350899"/>
                          <a:ext cx="2444146" cy="23620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Object 40">
              <a:extLst>
                <a:ext uri="{FF2B5EF4-FFF2-40B4-BE49-F238E27FC236}">
                  <a16:creationId xmlns:a16="http://schemas.microsoft.com/office/drawing/2014/main" id="{3ED5A9A3-97F1-89FA-495B-1CAA405CFBC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7882713"/>
                </p:ext>
              </p:extLst>
            </p:nvPr>
          </p:nvGraphicFramePr>
          <p:xfrm>
            <a:off x="4862095" y="1406149"/>
            <a:ext cx="2445304" cy="23685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2831027" imgH="2742119" progId="Prism9.Document">
                    <p:embed/>
                  </p:oleObj>
                </mc:Choice>
                <mc:Fallback>
                  <p:oleObj name="Prism 9" r:id="rId10" imgW="2831027" imgH="2742119" progId="Prism9.Document">
                    <p:embed/>
                    <p:pic>
                      <p:nvPicPr>
                        <p:cNvPr id="41" name="Object 40">
                          <a:extLst>
                            <a:ext uri="{FF2B5EF4-FFF2-40B4-BE49-F238E27FC236}">
                              <a16:creationId xmlns:a16="http://schemas.microsoft.com/office/drawing/2014/main" id="{3ED5A9A3-97F1-89FA-495B-1CAA405CFB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862095" y="1406149"/>
                          <a:ext cx="2445304" cy="23685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AABC3C9A-7137-02E9-6E55-E85890AAD79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7486288"/>
                </p:ext>
              </p:extLst>
            </p:nvPr>
          </p:nvGraphicFramePr>
          <p:xfrm>
            <a:off x="7280303" y="1423794"/>
            <a:ext cx="2450790" cy="23685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2837149" imgH="2742119" progId="Prism9.Document">
                    <p:embed/>
                  </p:oleObj>
                </mc:Choice>
                <mc:Fallback>
                  <p:oleObj name="Prism 9" r:id="rId12" imgW="2837149" imgH="2742119" progId="Prism9.Document">
                    <p:embed/>
                    <p:pic>
                      <p:nvPicPr>
                        <p:cNvPr id="42" name="Object 41">
                          <a:extLst>
                            <a:ext uri="{FF2B5EF4-FFF2-40B4-BE49-F238E27FC236}">
                              <a16:creationId xmlns:a16="http://schemas.microsoft.com/office/drawing/2014/main" id="{AABC3C9A-7137-02E9-6E55-E85890AAD79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7280303" y="1423794"/>
                          <a:ext cx="2450790" cy="23685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FF488DCE-E045-8A37-D2CD-62D6CD1337D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97480914"/>
                </p:ext>
              </p:extLst>
            </p:nvPr>
          </p:nvGraphicFramePr>
          <p:xfrm>
            <a:off x="35723" y="4009367"/>
            <a:ext cx="2901152" cy="26720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3256347" imgH="2999553" progId="Prism9.Document">
                    <p:embed/>
                  </p:oleObj>
                </mc:Choice>
                <mc:Fallback>
                  <p:oleObj name="Prism 9" r:id="rId14" imgW="3256347" imgH="2999553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FF488DCE-E045-8A37-D2CD-62D6CD1337D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35723" y="4009367"/>
                          <a:ext cx="2901152" cy="26720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040A4A7-B3F7-F225-AABB-73C65D67D55B}"/>
                </a:ext>
              </a:extLst>
            </p:cNvPr>
            <p:cNvSpPr txBox="1"/>
            <p:nvPr/>
          </p:nvSpPr>
          <p:spPr>
            <a:xfrm>
              <a:off x="39594" y="3812729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F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F0A0F70-7106-DC12-DAC9-C3DBBD78220F}"/>
                </a:ext>
              </a:extLst>
            </p:cNvPr>
            <p:cNvSpPr txBox="1"/>
            <p:nvPr/>
          </p:nvSpPr>
          <p:spPr>
            <a:xfrm>
              <a:off x="2868224" y="3793661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G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698BF22-D534-350C-44A5-5D2FAE052EEA}"/>
                </a:ext>
              </a:extLst>
            </p:cNvPr>
            <p:cNvSpPr txBox="1"/>
            <p:nvPr/>
          </p:nvSpPr>
          <p:spPr>
            <a:xfrm>
              <a:off x="5278457" y="3812729"/>
              <a:ext cx="5486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H</a:t>
              </a: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3BE250F8-E461-5E34-E115-58DF1E3C334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924662" y="3994513"/>
              <a:ext cx="3955191" cy="2971077"/>
              <a:chOff x="843675" y="1580436"/>
              <a:chExt cx="5413473" cy="4066515"/>
            </a:xfrm>
          </p:grpSpPr>
          <p:pic>
            <p:nvPicPr>
              <p:cNvPr id="33" name="Picture 32" descr="Background pattern&#10;&#10;Description automatically generated">
                <a:extLst>
                  <a:ext uri="{FF2B5EF4-FFF2-40B4-BE49-F238E27FC236}">
                    <a16:creationId xmlns:a16="http://schemas.microsoft.com/office/drawing/2014/main" id="{82363F52-3A63-0AE8-61BC-65F7C850B6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62716" y="1580436"/>
                <a:ext cx="2693352" cy="2020014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4" name="Picture 33" descr="Map&#10;&#10;Description automatically generated">
                <a:extLst>
                  <a:ext uri="{FF2B5EF4-FFF2-40B4-BE49-F238E27FC236}">
                    <a16:creationId xmlns:a16="http://schemas.microsoft.com/office/drawing/2014/main" id="{B8B39F32-C999-B038-5559-784C6B7D71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62716" y="3626127"/>
                <a:ext cx="2694432" cy="2020824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F59DA3C1-E3B6-237B-424F-1F7DD91F24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43675" y="3626937"/>
                <a:ext cx="2693351" cy="2020014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6" name="Picture 35" descr="Map&#10;&#10;Description automatically generated">
                <a:extLst>
                  <a:ext uri="{FF2B5EF4-FFF2-40B4-BE49-F238E27FC236}">
                    <a16:creationId xmlns:a16="http://schemas.microsoft.com/office/drawing/2014/main" id="{2FA5677C-4660-5BE7-D16E-E71C4B5F17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45501" y="1580436"/>
                <a:ext cx="2693352" cy="2020014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pic>
          <p:nvPicPr>
            <p:cNvPr id="32" name="Picture 31" descr="Background pattern&#10;&#10;Description automatically generated with low confidence">
              <a:extLst>
                <a:ext uri="{FF2B5EF4-FFF2-40B4-BE49-F238E27FC236}">
                  <a16:creationId xmlns:a16="http://schemas.microsoft.com/office/drawing/2014/main" id="{E7F58C03-9FEE-6408-C700-70F92E353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02893" y="4351657"/>
              <a:ext cx="1967818" cy="147586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A893B3A-CEE2-3041-594D-D4B299CE140A}"/>
                </a:ext>
              </a:extLst>
            </p:cNvPr>
            <p:cNvSpPr txBox="1"/>
            <p:nvPr/>
          </p:nvSpPr>
          <p:spPr>
            <a:xfrm>
              <a:off x="5924662" y="3722073"/>
              <a:ext cx="39718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Lungs 24 </a:t>
              </a:r>
              <a:r>
                <a:rPr lang="en-US" sz="1400" b="1" dirty="0" err="1"/>
                <a:t>wks</a:t>
              </a:r>
              <a:r>
                <a:rPr lang="en-US" sz="1400" b="1" dirty="0"/>
                <a:t> pi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FD1A5B7-21CE-F3F7-4035-4EB6AF12F445}"/>
                </a:ext>
              </a:extLst>
            </p:cNvPr>
            <p:cNvSpPr txBox="1"/>
            <p:nvPr/>
          </p:nvSpPr>
          <p:spPr>
            <a:xfrm>
              <a:off x="3253958" y="4055273"/>
              <a:ext cx="19167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Lung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03957FC-8B66-CAB0-8694-2500131509B1}"/>
                </a:ext>
              </a:extLst>
            </p:cNvPr>
            <p:cNvSpPr txBox="1"/>
            <p:nvPr/>
          </p:nvSpPr>
          <p:spPr>
            <a:xfrm>
              <a:off x="3202895" y="5827520"/>
              <a:ext cx="19865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Mouse 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183DCA2-4EFE-E5EC-F335-635E931A390D}"/>
                </a:ext>
              </a:extLst>
            </p:cNvPr>
            <p:cNvSpPr txBox="1"/>
            <p:nvPr/>
          </p:nvSpPr>
          <p:spPr>
            <a:xfrm>
              <a:off x="1526005" y="4648009"/>
              <a:ext cx="5486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FBE0438D-CDFD-AB71-1760-2C38DF6EA7E3}"/>
              </a:ext>
            </a:extLst>
          </p:cNvPr>
          <p:cNvSpPr txBox="1"/>
          <p:nvPr/>
        </p:nvSpPr>
        <p:spPr>
          <a:xfrm>
            <a:off x="-16099" y="7106957"/>
            <a:ext cx="12301840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7: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omparison of infection model with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orygis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streptomycin pre-treatment model was repeated with another pathogenic bovine mycobacteria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orygis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57BL/6 mice were given 20mg of streptomycin followed by 2 consecutive doses of 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orygis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24-hours apart. Mice were euthanized 4- and 24-weeks post-infection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-D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Strep-R </a:t>
            </a:r>
            <a:r>
              <a:rPr lang="en-US" sz="1400" i="1" dirty="0">
                <a:ea typeface="Calibri" panose="020F0502020204030204" pitchFamily="34" charset="0"/>
                <a:cs typeface="Times New Roman" panose="02020603050405020304" pitchFamily="18" charset="0"/>
              </a:rPr>
              <a:t>M. orygis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FUs were assessed in the large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small intestine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, MLNs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and lungs (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at each timepoint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F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Survival was monitored over the 24-week experiment. One mouse was flagged for euthanasia at 13-weeks post-infection (mouse 1)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G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 histopathology of the lungs was assessed for mouse 1. Shown is a representative image of the H&amp;E-stained section of its lungs (original magnification x40). 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H.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At the experimental endpoint of 24-weeks, the histopathology of the lungs was assessed for the surviving mice. Shown are representative images of the lungs (x40) sections.</a:t>
            </a:r>
          </a:p>
        </p:txBody>
      </p:sp>
    </p:spTree>
    <p:extLst>
      <p:ext uri="{BB962C8B-B14F-4D97-AF65-F5344CB8AC3E}">
        <p14:creationId xmlns:p14="http://schemas.microsoft.com/office/powerpoint/2010/main" val="2436164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1</TotalTime>
  <Words>1088</Words>
  <Application>Microsoft Office PowerPoint</Application>
  <PresentationFormat>Custom</PresentationFormat>
  <Paragraphs>144</Paragraphs>
  <Slides>8</Slides>
  <Notes>8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non Duffy</dc:creator>
  <cp:lastModifiedBy>Shannon Duffy</cp:lastModifiedBy>
  <cp:revision>5</cp:revision>
  <dcterms:created xsi:type="dcterms:W3CDTF">2023-08-23T14:02:18Z</dcterms:created>
  <dcterms:modified xsi:type="dcterms:W3CDTF">2023-09-15T14:19:42Z</dcterms:modified>
</cp:coreProperties>
</file>